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C889E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1B84849-956E-1148-93DF-11E2806BBCEA}" v="26" dt="2023-06-08T18:06:58.7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2257" autoAdjust="0"/>
    <p:restoredTop sz="96054"/>
  </p:normalViewPr>
  <p:slideViewPr>
    <p:cSldViewPr snapToGrid="0" showGuides="1">
      <p:cViewPr varScale="1">
        <p:scale>
          <a:sx n="123" d="100"/>
          <a:sy n="123" d="100"/>
        </p:scale>
        <p:origin x="272" y="18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yutaro Makino" userId="d3a9dc3dd267b724" providerId="LiveId" clId="{FB8A74A7-AE06-1D4E-90C8-3BE10419EEC4}"/>
    <pc:docChg chg="undo custSel modSld">
      <pc:chgData name="Ryutaro Makino" userId="d3a9dc3dd267b724" providerId="LiveId" clId="{FB8A74A7-AE06-1D4E-90C8-3BE10419EEC4}" dt="2022-08-06T23:49:53.665" v="8" actId="478"/>
      <pc:docMkLst>
        <pc:docMk/>
      </pc:docMkLst>
      <pc:sldChg chg="addSp delSp modSp mod">
        <pc:chgData name="Ryutaro Makino" userId="d3a9dc3dd267b724" providerId="LiveId" clId="{FB8A74A7-AE06-1D4E-90C8-3BE10419EEC4}" dt="2022-08-06T23:49:53.665" v="8" actId="478"/>
        <pc:sldMkLst>
          <pc:docMk/>
          <pc:sldMk cId="1731151971" sldId="257"/>
        </pc:sldMkLst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3" creationId="{EBF83A90-A06F-339F-2056-A70A3E94100D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5" creationId="{6E6EEE70-82A6-BCC9-0E94-1C58675A216D}"/>
          </ac:spMkLst>
        </pc:spChg>
        <pc:spChg chg="add del mod">
          <ac:chgData name="Ryutaro Makino" userId="d3a9dc3dd267b724" providerId="LiveId" clId="{FB8A74A7-AE06-1D4E-90C8-3BE10419EEC4}" dt="2022-08-03T11:25:32.653" v="2"/>
          <ac:spMkLst>
            <pc:docMk/>
            <pc:sldMk cId="1731151971" sldId="257"/>
            <ac:spMk id="6" creationId="{1EC8A13D-B120-C655-29A0-158ACC2FE9E7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7" creationId="{4CD61E5D-2349-B187-41C8-46EF8E639584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8" creationId="{1BE51938-9EDD-FA8D-1096-40A21FC76563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9" creationId="{2B30035A-53F2-AA3A-C6F9-ABB2F543E532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10" creationId="{8947756F-0AA1-CBAC-CD19-A42EAB74C168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11" creationId="{8589F3DB-3E2B-259C-D377-B26A1B8221F3}"/>
          </ac:spMkLst>
        </pc:spChg>
        <pc:spChg chg="del">
          <ac:chgData name="Ryutaro Makino" userId="d3a9dc3dd267b724" providerId="LiveId" clId="{FB8A74A7-AE06-1D4E-90C8-3BE10419EEC4}" dt="2022-08-06T23:49:48.574" v="5" actId="21"/>
          <ac:spMkLst>
            <pc:docMk/>
            <pc:sldMk cId="1731151971" sldId="257"/>
            <ac:spMk id="12" creationId="{6856A3CB-DE47-50B2-9E99-B3CC3C233D03}"/>
          </ac:spMkLst>
        </pc:spChg>
        <pc:spChg chg="add del mod">
          <ac:chgData name="Ryutaro Makino" userId="d3a9dc3dd267b724" providerId="LiveId" clId="{FB8A74A7-AE06-1D4E-90C8-3BE10419EEC4}" dt="2022-08-06T23:49:53.665" v="8" actId="478"/>
          <ac:spMkLst>
            <pc:docMk/>
            <pc:sldMk cId="1731151971" sldId="257"/>
            <ac:spMk id="14" creationId="{714AB9F9-A2D2-E188-4458-4987FD67054B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16" creationId="{CD9300D7-D29B-1B2B-1D51-555CB997CBC1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17" creationId="{42136784-EC4F-9067-1764-A8E0614D7FD1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18" creationId="{13622E77-CEAA-A432-004F-DA78A5A6D774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19" creationId="{D5E5A5A8-86A7-0E0D-8E39-F085F39BFBA0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20" creationId="{A1752F6F-735C-276D-0CA2-352DE803E32C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21" creationId="{77D63627-2298-35AA-ADCE-63A7F8F6BA38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22" creationId="{DCA06B0B-0A24-0DF6-C23F-D1917574515D}"/>
          </ac:spMkLst>
        </pc:spChg>
        <pc:spChg chg="add mod">
          <ac:chgData name="Ryutaro Makino" userId="d3a9dc3dd267b724" providerId="LiveId" clId="{FB8A74A7-AE06-1D4E-90C8-3BE10419EEC4}" dt="2022-08-06T23:49:49.040" v="6"/>
          <ac:spMkLst>
            <pc:docMk/>
            <pc:sldMk cId="1731151971" sldId="257"/>
            <ac:spMk id="23" creationId="{B19177F5-E85E-66B8-DAC9-524303F4CEC6}"/>
          </ac:spMkLst>
        </pc:spChg>
        <pc:grpChg chg="add">
          <ac:chgData name="Ryutaro Makino" userId="d3a9dc3dd267b724" providerId="LiveId" clId="{FB8A74A7-AE06-1D4E-90C8-3BE10419EEC4}" dt="2022-08-06T23:49:52.228" v="7" actId="164"/>
          <ac:grpSpMkLst>
            <pc:docMk/>
            <pc:sldMk cId="1731151971" sldId="257"/>
            <ac:grpSpMk id="24" creationId="{AEFED5A6-2116-8704-5872-8DEBCFC79726}"/>
          </ac:grpSpMkLst>
        </pc:grpChg>
        <pc:picChg chg="del mod">
          <ac:chgData name="Ryutaro Makino" userId="d3a9dc3dd267b724" providerId="LiveId" clId="{FB8A74A7-AE06-1D4E-90C8-3BE10419EEC4}" dt="2022-08-06T23:49:48.574" v="5" actId="21"/>
          <ac:picMkLst>
            <pc:docMk/>
            <pc:sldMk cId="1731151971" sldId="257"/>
            <ac:picMk id="4" creationId="{00000000-0000-0000-0000-000000000000}"/>
          </ac:picMkLst>
        </pc:picChg>
        <pc:picChg chg="add mod">
          <ac:chgData name="Ryutaro Makino" userId="d3a9dc3dd267b724" providerId="LiveId" clId="{FB8A74A7-AE06-1D4E-90C8-3BE10419EEC4}" dt="2022-08-06T23:49:49.040" v="6"/>
          <ac:picMkLst>
            <pc:docMk/>
            <pc:sldMk cId="1731151971" sldId="257"/>
            <ac:picMk id="15" creationId="{003ABA7B-91F7-AD20-283B-6E50B2AD94C3}"/>
          </ac:picMkLst>
        </pc:picChg>
      </pc:sldChg>
    </pc:docChg>
  </pc:docChgLst>
  <pc:docChgLst>
    <pc:chgData name="Ryutaro Makino" userId="d3a9dc3dd267b724" providerId="LiveId" clId="{81B84849-956E-1148-93DF-11E2806BBCEA}"/>
    <pc:docChg chg="modSld">
      <pc:chgData name="Ryutaro Makino" userId="d3a9dc3dd267b724" providerId="LiveId" clId="{81B84849-956E-1148-93DF-11E2806BBCEA}" dt="2023-06-08T18:06:58.789" v="31" actId="206"/>
      <pc:docMkLst>
        <pc:docMk/>
      </pc:docMkLst>
      <pc:sldChg chg="modSp mod">
        <pc:chgData name="Ryutaro Makino" userId="d3a9dc3dd267b724" providerId="LiveId" clId="{81B84849-956E-1148-93DF-11E2806BBCEA}" dt="2023-06-08T18:06:58.789" v="31" actId="206"/>
        <pc:sldMkLst>
          <pc:docMk/>
          <pc:sldMk cId="1731151971" sldId="257"/>
        </pc:sldMkLst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16" creationId="{CD9300D7-D29B-1B2B-1D51-555CB997CBC1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17" creationId="{42136784-EC4F-9067-1764-A8E0614D7FD1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18" creationId="{13622E77-CEAA-A432-004F-DA78A5A6D774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19" creationId="{D5E5A5A8-86A7-0E0D-8E39-F085F39BFBA0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20" creationId="{A1752F6F-735C-276D-0CA2-352DE803E32C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21" creationId="{77D63627-2298-35AA-ADCE-63A7F8F6BA38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22" creationId="{DCA06B0B-0A24-0DF6-C23F-D1917574515D}"/>
          </ac:spMkLst>
        </pc:spChg>
        <pc:spChg chg="mod">
          <ac:chgData name="Ryutaro Makino" userId="d3a9dc3dd267b724" providerId="LiveId" clId="{81B84849-956E-1148-93DF-11E2806BBCEA}" dt="2023-06-08T18:06:58.789" v="31" actId="206"/>
          <ac:spMkLst>
            <pc:docMk/>
            <pc:sldMk cId="1731151971" sldId="257"/>
            <ac:spMk id="23" creationId="{B19177F5-E85E-66B8-DAC9-524303F4CEC6}"/>
          </ac:spMkLst>
        </pc:spChg>
        <pc:grpChg chg="mod">
          <ac:chgData name="Ryutaro Makino" userId="d3a9dc3dd267b724" providerId="LiveId" clId="{81B84849-956E-1148-93DF-11E2806BBCEA}" dt="2023-06-08T18:06:58.789" v="31" actId="206"/>
          <ac:grpSpMkLst>
            <pc:docMk/>
            <pc:sldMk cId="1731151971" sldId="257"/>
            <ac:grpSpMk id="24" creationId="{AEFED5A6-2116-8704-5872-8DEBCFC79726}"/>
          </ac:grpSpMkLst>
        </pc:grpChg>
        <pc:picChg chg="mod">
          <ac:chgData name="Ryutaro Makino" userId="d3a9dc3dd267b724" providerId="LiveId" clId="{81B84849-956E-1148-93DF-11E2806BBCEA}" dt="2023-06-08T18:06:58.789" v="31" actId="206"/>
          <ac:picMkLst>
            <pc:docMk/>
            <pc:sldMk cId="1731151971" sldId="257"/>
            <ac:picMk id="15" creationId="{003ABA7B-91F7-AD20-283B-6E50B2AD94C3}"/>
          </ac:picMkLst>
        </pc:picChg>
      </pc:sldChg>
    </pc:docChg>
  </pc:docChgLst>
  <pc:docChgLst>
    <pc:chgData name="Ryutaro Makino" userId="d3a9dc3dd267b724" providerId="LiveId" clId="{8094593E-294A-DD40-A62E-877C05861122}"/>
    <pc:docChg chg="undo custSel delSld modSld">
      <pc:chgData name="Ryutaro Makino" userId="d3a9dc3dd267b724" providerId="LiveId" clId="{8094593E-294A-DD40-A62E-877C05861122}" dt="2022-05-18T15:14:37.038" v="235" actId="1038"/>
      <pc:docMkLst>
        <pc:docMk/>
      </pc:docMkLst>
      <pc:sldChg chg="addSp delSp modSp mod">
        <pc:chgData name="Ryutaro Makino" userId="d3a9dc3dd267b724" providerId="LiveId" clId="{8094593E-294A-DD40-A62E-877C05861122}" dt="2022-05-18T15:14:37.038" v="235" actId="1038"/>
        <pc:sldMkLst>
          <pc:docMk/>
          <pc:sldMk cId="1731151971" sldId="257"/>
        </pc:sldMkLst>
        <pc:spChg chg="del mod">
          <ac:chgData name="Ryutaro Makino" userId="d3a9dc3dd267b724" providerId="LiveId" clId="{8094593E-294A-DD40-A62E-877C05861122}" dt="2022-05-15T02:53:07.346" v="5" actId="478"/>
          <ac:spMkLst>
            <pc:docMk/>
            <pc:sldMk cId="1731151971" sldId="257"/>
            <ac:spMk id="2" creationId="{00000000-0000-0000-0000-000000000000}"/>
          </ac:spMkLst>
        </pc:spChg>
        <pc:spChg chg="add mod">
          <ac:chgData name="Ryutaro Makino" userId="d3a9dc3dd267b724" providerId="LiveId" clId="{8094593E-294A-DD40-A62E-877C05861122}" dt="2022-05-17T03:51:27.852" v="206" actId="1076"/>
          <ac:spMkLst>
            <pc:docMk/>
            <pc:sldMk cId="1731151971" sldId="257"/>
            <ac:spMk id="2" creationId="{2D7EE7B1-F375-E567-6CAE-A8CAC003CFEA}"/>
          </ac:spMkLst>
        </pc:spChg>
        <pc:spChg chg="add mod">
          <ac:chgData name="Ryutaro Makino" userId="d3a9dc3dd267b724" providerId="LiveId" clId="{8094593E-294A-DD40-A62E-877C05861122}" dt="2022-05-17T03:51:22.196" v="205" actId="1076"/>
          <ac:spMkLst>
            <pc:docMk/>
            <pc:sldMk cId="1731151971" sldId="257"/>
            <ac:spMk id="3" creationId="{EBF83A90-A06F-339F-2056-A70A3E94100D}"/>
          </ac:spMkLst>
        </pc:spChg>
        <pc:spChg chg="add mod">
          <ac:chgData name="Ryutaro Makino" userId="d3a9dc3dd267b724" providerId="LiveId" clId="{8094593E-294A-DD40-A62E-877C05861122}" dt="2022-05-17T03:51:22.196" v="205" actId="1076"/>
          <ac:spMkLst>
            <pc:docMk/>
            <pc:sldMk cId="1731151971" sldId="257"/>
            <ac:spMk id="5" creationId="{6E6EEE70-82A6-BCC9-0E94-1C58675A216D}"/>
          </ac:spMkLst>
        </pc:spChg>
        <pc:spChg chg="add del mod">
          <ac:chgData name="Ryutaro Makino" userId="d3a9dc3dd267b724" providerId="LiveId" clId="{8094593E-294A-DD40-A62E-877C05861122}" dt="2022-05-17T03:54:28.223" v="216"/>
          <ac:spMkLst>
            <pc:docMk/>
            <pc:sldMk cId="1731151971" sldId="257"/>
            <ac:spMk id="6" creationId="{5B72053E-8727-3DB6-AD96-9743FBC59026}"/>
          </ac:spMkLst>
        </pc:spChg>
        <pc:spChg chg="add del mod">
          <ac:chgData name="Ryutaro Makino" userId="d3a9dc3dd267b724" providerId="LiveId" clId="{8094593E-294A-DD40-A62E-877C05861122}" dt="2022-05-18T15:03:16.625" v="232"/>
          <ac:spMkLst>
            <pc:docMk/>
            <pc:sldMk cId="1731151971" sldId="257"/>
            <ac:spMk id="6" creationId="{C502D0F1-BE7F-1076-6BDA-3D2ED091F38A}"/>
          </ac:spMkLst>
        </pc:spChg>
        <pc:spChg chg="add mod">
          <ac:chgData name="Ryutaro Makino" userId="d3a9dc3dd267b724" providerId="LiveId" clId="{8094593E-294A-DD40-A62E-877C05861122}" dt="2022-05-17T03:54:06.371" v="213" actId="688"/>
          <ac:spMkLst>
            <pc:docMk/>
            <pc:sldMk cId="1731151971" sldId="257"/>
            <ac:spMk id="7" creationId="{4CD61E5D-2349-B187-41C8-46EF8E639584}"/>
          </ac:spMkLst>
        </pc:spChg>
        <pc:spChg chg="add mod">
          <ac:chgData name="Ryutaro Makino" userId="d3a9dc3dd267b724" providerId="LiveId" clId="{8094593E-294A-DD40-A62E-877C05861122}" dt="2022-05-17T03:51:22.196" v="205" actId="1076"/>
          <ac:spMkLst>
            <pc:docMk/>
            <pc:sldMk cId="1731151971" sldId="257"/>
            <ac:spMk id="8" creationId="{1BE51938-9EDD-FA8D-1096-40A21FC76563}"/>
          </ac:spMkLst>
        </pc:spChg>
        <pc:spChg chg="add mod">
          <ac:chgData name="Ryutaro Makino" userId="d3a9dc3dd267b724" providerId="LiveId" clId="{8094593E-294A-DD40-A62E-877C05861122}" dt="2022-05-17T03:51:22.196" v="205" actId="1076"/>
          <ac:spMkLst>
            <pc:docMk/>
            <pc:sldMk cId="1731151971" sldId="257"/>
            <ac:spMk id="9" creationId="{2B30035A-53F2-AA3A-C6F9-ABB2F543E532}"/>
          </ac:spMkLst>
        </pc:spChg>
        <pc:spChg chg="add mod">
          <ac:chgData name="Ryutaro Makino" userId="d3a9dc3dd267b724" providerId="LiveId" clId="{8094593E-294A-DD40-A62E-877C05861122}" dt="2022-05-18T15:14:37.038" v="235" actId="1038"/>
          <ac:spMkLst>
            <pc:docMk/>
            <pc:sldMk cId="1731151971" sldId="257"/>
            <ac:spMk id="10" creationId="{8947756F-0AA1-CBAC-CD19-A42EAB74C168}"/>
          </ac:spMkLst>
        </pc:spChg>
        <pc:spChg chg="add mod">
          <ac:chgData name="Ryutaro Makino" userId="d3a9dc3dd267b724" providerId="LiveId" clId="{8094593E-294A-DD40-A62E-877C05861122}" dt="2022-05-17T05:47:24.075" v="229" actId="1038"/>
          <ac:spMkLst>
            <pc:docMk/>
            <pc:sldMk cId="1731151971" sldId="257"/>
            <ac:spMk id="11" creationId="{8589F3DB-3E2B-259C-D377-B26A1B8221F3}"/>
          </ac:spMkLst>
        </pc:spChg>
        <pc:spChg chg="add mod">
          <ac:chgData name="Ryutaro Makino" userId="d3a9dc3dd267b724" providerId="LiveId" clId="{8094593E-294A-DD40-A62E-877C05861122}" dt="2022-05-17T03:51:22.196" v="205" actId="1076"/>
          <ac:spMkLst>
            <pc:docMk/>
            <pc:sldMk cId="1731151971" sldId="257"/>
            <ac:spMk id="12" creationId="{6856A3CB-DE47-50B2-9E99-B3CC3C233D03}"/>
          </ac:spMkLst>
        </pc:spChg>
        <pc:spChg chg="add mod">
          <ac:chgData name="Ryutaro Makino" userId="d3a9dc3dd267b724" providerId="LiveId" clId="{8094593E-294A-DD40-A62E-877C05861122}" dt="2022-05-17T03:53:43.538" v="212" actId="20577"/>
          <ac:spMkLst>
            <pc:docMk/>
            <pc:sldMk cId="1731151971" sldId="257"/>
            <ac:spMk id="13" creationId="{2A1EDF2F-51AB-3C56-A446-B38F84547406}"/>
          </ac:spMkLst>
        </pc:spChg>
        <pc:picChg chg="mod modCrop">
          <ac:chgData name="Ryutaro Makino" userId="d3a9dc3dd267b724" providerId="LiveId" clId="{8094593E-294A-DD40-A62E-877C05861122}" dt="2022-05-17T03:51:22.196" v="205" actId="1076"/>
          <ac:picMkLst>
            <pc:docMk/>
            <pc:sldMk cId="1731151971" sldId="257"/>
            <ac:picMk id="4" creationId="{00000000-0000-0000-0000-000000000000}"/>
          </ac:picMkLst>
        </pc:picChg>
        <pc:picChg chg="del mod">
          <ac:chgData name="Ryutaro Makino" userId="d3a9dc3dd267b724" providerId="LiveId" clId="{8094593E-294A-DD40-A62E-877C05861122}" dt="2022-05-15T02:53:02.186" v="1" actId="21"/>
          <ac:picMkLst>
            <pc:docMk/>
            <pc:sldMk cId="1731151971" sldId="257"/>
            <ac:picMk id="6" creationId="{00000000-0000-0000-0000-000000000000}"/>
          </ac:picMkLst>
        </pc:picChg>
      </pc:sldChg>
      <pc:sldChg chg="addSp delSp modSp del mod">
        <pc:chgData name="Ryutaro Makino" userId="d3a9dc3dd267b724" providerId="LiveId" clId="{8094593E-294A-DD40-A62E-877C05861122}" dt="2022-05-15T03:01:46.318" v="144" actId="2696"/>
        <pc:sldMkLst>
          <pc:docMk/>
          <pc:sldMk cId="4280445662" sldId="258"/>
        </pc:sldMkLst>
        <pc:picChg chg="add del mod">
          <ac:chgData name="Ryutaro Makino" userId="d3a9dc3dd267b724" providerId="LiveId" clId="{8094593E-294A-DD40-A62E-877C05861122}" dt="2022-05-15T03:01:44.791" v="143" actId="478"/>
          <ac:picMkLst>
            <pc:docMk/>
            <pc:sldMk cId="4280445662" sldId="258"/>
            <ac:picMk id="4" creationId="{5380AFE5-0A67-67D7-B14A-8ACEDA9A34FC}"/>
          </ac:picMkLst>
        </pc:picChg>
      </pc:sldChg>
      <pc:sldChg chg="del">
        <pc:chgData name="Ryutaro Makino" userId="d3a9dc3dd267b724" providerId="LiveId" clId="{8094593E-294A-DD40-A62E-877C05861122}" dt="2022-05-15T03:01:47.632" v="145" actId="2696"/>
        <pc:sldMkLst>
          <pc:docMk/>
          <pc:sldMk cId="138557584" sldId="25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4B04023-B5ED-D543-9DD0-5B14A298294B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7021958-A1F9-3540-B923-D8463C6CEA8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77293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7021958-A1F9-3540-B923-D8463C6CEA80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32578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6610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1650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32549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91111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49512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4364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145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689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8406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999791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44715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80A5F3-8590-4A0C-80BD-EB9956DEB792}" type="datetimeFigureOut">
              <a:rPr kumimoji="1" lang="ja-JP" altLang="en-US" smtClean="0"/>
              <a:t>2023/8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10176-3976-4028-93C2-086B2DE9FA5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84432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4" name="グループ化 23">
            <a:extLst>
              <a:ext uri="{FF2B5EF4-FFF2-40B4-BE49-F238E27FC236}">
                <a16:creationId xmlns:a16="http://schemas.microsoft.com/office/drawing/2014/main" id="{AEFED5A6-2116-8704-5872-8DEBCFC79726}"/>
              </a:ext>
            </a:extLst>
          </p:cNvPr>
          <p:cNvGrpSpPr/>
          <p:nvPr/>
        </p:nvGrpSpPr>
        <p:grpSpPr>
          <a:xfrm>
            <a:off x="3870593" y="326349"/>
            <a:ext cx="4450814" cy="4653275"/>
            <a:chOff x="3771313" y="274812"/>
            <a:chExt cx="4990972" cy="5466303"/>
          </a:xfrm>
        </p:grpSpPr>
        <p:pic>
          <p:nvPicPr>
            <p:cNvPr id="15" name="コンテンツ プレースホルダー 3">
              <a:extLst>
                <a:ext uri="{FF2B5EF4-FFF2-40B4-BE49-F238E27FC236}">
                  <a16:creationId xmlns:a16="http://schemas.microsoft.com/office/drawing/2014/main" id="{003ABA7B-91F7-AD20-283B-6E50B2AD94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40000"/>
                      </a14:imgEffect>
                    </a14:imgLayer>
                  </a14:imgProps>
                </a:ext>
              </a:extLst>
            </a:blip>
            <a:srcRect l="20415" t="9594" r="22219" b="11870"/>
            <a:stretch/>
          </p:blipFill>
          <p:spPr>
            <a:xfrm>
              <a:off x="3771313" y="274812"/>
              <a:ext cx="4990972" cy="5466303"/>
            </a:xfrm>
            <a:prstGeom prst="rect">
              <a:avLst/>
            </a:prstGeom>
          </p:spPr>
        </p:pic>
        <p:sp>
          <p:nvSpPr>
            <p:cNvPr id="16" name="フリーフォーム 15">
              <a:extLst>
                <a:ext uri="{FF2B5EF4-FFF2-40B4-BE49-F238E27FC236}">
                  <a16:creationId xmlns:a16="http://schemas.microsoft.com/office/drawing/2014/main" id="{CD9300D7-D29B-1B2B-1D51-555CB997CBC1}"/>
                </a:ext>
              </a:extLst>
            </p:cNvPr>
            <p:cNvSpPr/>
            <p:nvPr/>
          </p:nvSpPr>
          <p:spPr>
            <a:xfrm>
              <a:off x="6520038" y="1036631"/>
              <a:ext cx="1208901" cy="1057550"/>
            </a:xfrm>
            <a:custGeom>
              <a:avLst/>
              <a:gdLst>
                <a:gd name="connsiteX0" fmla="*/ 161529 w 1165507"/>
                <a:gd name="connsiteY0" fmla="*/ 652603 h 976941"/>
                <a:gd name="connsiteX1" fmla="*/ 82399 w 1165507"/>
                <a:gd name="connsiteY1" fmla="*/ 749318 h 976941"/>
                <a:gd name="connsiteX2" fmla="*/ 3268 w 1165507"/>
                <a:gd name="connsiteY2" fmla="*/ 635018 h 976941"/>
                <a:gd name="connsiteX3" fmla="*/ 20853 w 1165507"/>
                <a:gd name="connsiteY3" fmla="*/ 467964 h 976941"/>
                <a:gd name="connsiteX4" fmla="*/ 73606 w 1165507"/>
                <a:gd name="connsiteY4" fmla="*/ 239364 h 976941"/>
                <a:gd name="connsiteX5" fmla="*/ 179114 w 1165507"/>
                <a:gd name="connsiteY5" fmla="*/ 116272 h 976941"/>
                <a:gd name="connsiteX6" fmla="*/ 442883 w 1165507"/>
                <a:gd name="connsiteY6" fmla="*/ 19557 h 976941"/>
                <a:gd name="connsiteX7" fmla="*/ 803368 w 1165507"/>
                <a:gd name="connsiteY7" fmla="*/ 10764 h 976941"/>
                <a:gd name="connsiteX8" fmla="*/ 952837 w 1165507"/>
                <a:gd name="connsiteY8" fmla="*/ 19557 h 976941"/>
                <a:gd name="connsiteX9" fmla="*/ 1075929 w 1165507"/>
                <a:gd name="connsiteY9" fmla="*/ 239364 h 976941"/>
                <a:gd name="connsiteX10" fmla="*/ 1155060 w 1165507"/>
                <a:gd name="connsiteY10" fmla="*/ 467964 h 976941"/>
                <a:gd name="connsiteX11" fmla="*/ 1155060 w 1165507"/>
                <a:gd name="connsiteY11" fmla="*/ 599849 h 976941"/>
                <a:gd name="connsiteX12" fmla="*/ 1067137 w 1165507"/>
                <a:gd name="connsiteY12" fmla="*/ 740526 h 976941"/>
                <a:gd name="connsiteX13" fmla="*/ 952837 w 1165507"/>
                <a:gd name="connsiteY13" fmla="*/ 863618 h 976941"/>
                <a:gd name="connsiteX14" fmla="*/ 715445 w 1165507"/>
                <a:gd name="connsiteY14" fmla="*/ 969126 h 976941"/>
                <a:gd name="connsiteX15" fmla="*/ 486845 w 1165507"/>
                <a:gd name="connsiteY15" fmla="*/ 969126 h 976941"/>
                <a:gd name="connsiteX16" fmla="*/ 310999 w 1165507"/>
                <a:gd name="connsiteY16" fmla="*/ 969126 h 976941"/>
                <a:gd name="connsiteX17" fmla="*/ 187906 w 1165507"/>
                <a:gd name="connsiteY17" fmla="*/ 863618 h 976941"/>
                <a:gd name="connsiteX18" fmla="*/ 249453 w 1165507"/>
                <a:gd name="connsiteY18" fmla="*/ 802072 h 976941"/>
                <a:gd name="connsiteX19" fmla="*/ 161529 w 1165507"/>
                <a:gd name="connsiteY19" fmla="*/ 652603 h 976941"/>
                <a:gd name="connsiteX0" fmla="*/ 161529 w 1203322"/>
                <a:gd name="connsiteY0" fmla="*/ 652603 h 976941"/>
                <a:gd name="connsiteX1" fmla="*/ 82399 w 1203322"/>
                <a:gd name="connsiteY1" fmla="*/ 749318 h 976941"/>
                <a:gd name="connsiteX2" fmla="*/ 3268 w 1203322"/>
                <a:gd name="connsiteY2" fmla="*/ 635018 h 976941"/>
                <a:gd name="connsiteX3" fmla="*/ 20853 w 1203322"/>
                <a:gd name="connsiteY3" fmla="*/ 467964 h 976941"/>
                <a:gd name="connsiteX4" fmla="*/ 73606 w 1203322"/>
                <a:gd name="connsiteY4" fmla="*/ 239364 h 976941"/>
                <a:gd name="connsiteX5" fmla="*/ 179114 w 1203322"/>
                <a:gd name="connsiteY5" fmla="*/ 116272 h 976941"/>
                <a:gd name="connsiteX6" fmla="*/ 442883 w 1203322"/>
                <a:gd name="connsiteY6" fmla="*/ 19557 h 976941"/>
                <a:gd name="connsiteX7" fmla="*/ 803368 w 1203322"/>
                <a:gd name="connsiteY7" fmla="*/ 10764 h 976941"/>
                <a:gd name="connsiteX8" fmla="*/ 952837 w 1203322"/>
                <a:gd name="connsiteY8" fmla="*/ 19557 h 976941"/>
                <a:gd name="connsiteX9" fmla="*/ 1075929 w 1203322"/>
                <a:gd name="connsiteY9" fmla="*/ 239364 h 976941"/>
                <a:gd name="connsiteX10" fmla="*/ 1200520 w 1203322"/>
                <a:gd name="connsiteY10" fmla="*/ 483839 h 976941"/>
                <a:gd name="connsiteX11" fmla="*/ 1155060 w 1203322"/>
                <a:gd name="connsiteY11" fmla="*/ 599849 h 976941"/>
                <a:gd name="connsiteX12" fmla="*/ 1067137 w 1203322"/>
                <a:gd name="connsiteY12" fmla="*/ 740526 h 976941"/>
                <a:gd name="connsiteX13" fmla="*/ 952837 w 1203322"/>
                <a:gd name="connsiteY13" fmla="*/ 863618 h 976941"/>
                <a:gd name="connsiteX14" fmla="*/ 715445 w 1203322"/>
                <a:gd name="connsiteY14" fmla="*/ 969126 h 976941"/>
                <a:gd name="connsiteX15" fmla="*/ 486845 w 1203322"/>
                <a:gd name="connsiteY15" fmla="*/ 969126 h 976941"/>
                <a:gd name="connsiteX16" fmla="*/ 310999 w 1203322"/>
                <a:gd name="connsiteY16" fmla="*/ 969126 h 976941"/>
                <a:gd name="connsiteX17" fmla="*/ 187906 w 1203322"/>
                <a:gd name="connsiteY17" fmla="*/ 863618 h 976941"/>
                <a:gd name="connsiteX18" fmla="*/ 249453 w 1203322"/>
                <a:gd name="connsiteY18" fmla="*/ 802072 h 976941"/>
                <a:gd name="connsiteX19" fmla="*/ 161529 w 1203322"/>
                <a:gd name="connsiteY19" fmla="*/ 652603 h 976941"/>
                <a:gd name="connsiteX0" fmla="*/ 161529 w 1203322"/>
                <a:gd name="connsiteY0" fmla="*/ 647289 h 971627"/>
                <a:gd name="connsiteX1" fmla="*/ 82399 w 1203322"/>
                <a:gd name="connsiteY1" fmla="*/ 744004 h 971627"/>
                <a:gd name="connsiteX2" fmla="*/ 3268 w 1203322"/>
                <a:gd name="connsiteY2" fmla="*/ 629704 h 971627"/>
                <a:gd name="connsiteX3" fmla="*/ 20853 w 1203322"/>
                <a:gd name="connsiteY3" fmla="*/ 462650 h 971627"/>
                <a:gd name="connsiteX4" fmla="*/ 73606 w 1203322"/>
                <a:gd name="connsiteY4" fmla="*/ 234050 h 971627"/>
                <a:gd name="connsiteX5" fmla="*/ 179114 w 1203322"/>
                <a:gd name="connsiteY5" fmla="*/ 110958 h 971627"/>
                <a:gd name="connsiteX6" fmla="*/ 442883 w 1203322"/>
                <a:gd name="connsiteY6" fmla="*/ 14243 h 971627"/>
                <a:gd name="connsiteX7" fmla="*/ 803368 w 1203322"/>
                <a:gd name="connsiteY7" fmla="*/ 5450 h 971627"/>
                <a:gd name="connsiteX8" fmla="*/ 962033 w 1203322"/>
                <a:gd name="connsiteY8" fmla="*/ 62412 h 971627"/>
                <a:gd name="connsiteX9" fmla="*/ 1075929 w 1203322"/>
                <a:gd name="connsiteY9" fmla="*/ 234050 h 971627"/>
                <a:gd name="connsiteX10" fmla="*/ 1200520 w 1203322"/>
                <a:gd name="connsiteY10" fmla="*/ 478525 h 971627"/>
                <a:gd name="connsiteX11" fmla="*/ 1155060 w 1203322"/>
                <a:gd name="connsiteY11" fmla="*/ 594535 h 971627"/>
                <a:gd name="connsiteX12" fmla="*/ 1067137 w 1203322"/>
                <a:gd name="connsiteY12" fmla="*/ 735212 h 971627"/>
                <a:gd name="connsiteX13" fmla="*/ 952837 w 1203322"/>
                <a:gd name="connsiteY13" fmla="*/ 858304 h 971627"/>
                <a:gd name="connsiteX14" fmla="*/ 715445 w 1203322"/>
                <a:gd name="connsiteY14" fmla="*/ 963812 h 971627"/>
                <a:gd name="connsiteX15" fmla="*/ 486845 w 1203322"/>
                <a:gd name="connsiteY15" fmla="*/ 963812 h 971627"/>
                <a:gd name="connsiteX16" fmla="*/ 310999 w 1203322"/>
                <a:gd name="connsiteY16" fmla="*/ 963812 h 971627"/>
                <a:gd name="connsiteX17" fmla="*/ 187906 w 1203322"/>
                <a:gd name="connsiteY17" fmla="*/ 858304 h 971627"/>
                <a:gd name="connsiteX18" fmla="*/ 249453 w 1203322"/>
                <a:gd name="connsiteY18" fmla="*/ 796758 h 971627"/>
                <a:gd name="connsiteX19" fmla="*/ 161529 w 1203322"/>
                <a:gd name="connsiteY19" fmla="*/ 647289 h 971627"/>
                <a:gd name="connsiteX0" fmla="*/ 161529 w 1203322"/>
                <a:gd name="connsiteY0" fmla="*/ 672358 h 996696"/>
                <a:gd name="connsiteX1" fmla="*/ 82399 w 1203322"/>
                <a:gd name="connsiteY1" fmla="*/ 769073 h 996696"/>
                <a:gd name="connsiteX2" fmla="*/ 3268 w 1203322"/>
                <a:gd name="connsiteY2" fmla="*/ 654773 h 996696"/>
                <a:gd name="connsiteX3" fmla="*/ 20853 w 1203322"/>
                <a:gd name="connsiteY3" fmla="*/ 487719 h 996696"/>
                <a:gd name="connsiteX4" fmla="*/ 73606 w 1203322"/>
                <a:gd name="connsiteY4" fmla="*/ 259119 h 996696"/>
                <a:gd name="connsiteX5" fmla="*/ 179114 w 1203322"/>
                <a:gd name="connsiteY5" fmla="*/ 136027 h 996696"/>
                <a:gd name="connsiteX6" fmla="*/ 442883 w 1203322"/>
                <a:gd name="connsiteY6" fmla="*/ 39312 h 996696"/>
                <a:gd name="connsiteX7" fmla="*/ 835556 w 1203322"/>
                <a:gd name="connsiteY7" fmla="*/ 1617 h 996696"/>
                <a:gd name="connsiteX8" fmla="*/ 962033 w 1203322"/>
                <a:gd name="connsiteY8" fmla="*/ 87481 h 996696"/>
                <a:gd name="connsiteX9" fmla="*/ 1075929 w 1203322"/>
                <a:gd name="connsiteY9" fmla="*/ 259119 h 996696"/>
                <a:gd name="connsiteX10" fmla="*/ 1200520 w 1203322"/>
                <a:gd name="connsiteY10" fmla="*/ 503594 h 996696"/>
                <a:gd name="connsiteX11" fmla="*/ 1155060 w 1203322"/>
                <a:gd name="connsiteY11" fmla="*/ 619604 h 996696"/>
                <a:gd name="connsiteX12" fmla="*/ 1067137 w 1203322"/>
                <a:gd name="connsiteY12" fmla="*/ 760281 h 996696"/>
                <a:gd name="connsiteX13" fmla="*/ 952837 w 1203322"/>
                <a:gd name="connsiteY13" fmla="*/ 883373 h 996696"/>
                <a:gd name="connsiteX14" fmla="*/ 715445 w 1203322"/>
                <a:gd name="connsiteY14" fmla="*/ 988881 h 996696"/>
                <a:gd name="connsiteX15" fmla="*/ 486845 w 1203322"/>
                <a:gd name="connsiteY15" fmla="*/ 988881 h 996696"/>
                <a:gd name="connsiteX16" fmla="*/ 310999 w 1203322"/>
                <a:gd name="connsiteY16" fmla="*/ 988881 h 996696"/>
                <a:gd name="connsiteX17" fmla="*/ 187906 w 1203322"/>
                <a:gd name="connsiteY17" fmla="*/ 883373 h 996696"/>
                <a:gd name="connsiteX18" fmla="*/ 249453 w 1203322"/>
                <a:gd name="connsiteY18" fmla="*/ 821827 h 996696"/>
                <a:gd name="connsiteX19" fmla="*/ 161529 w 1203322"/>
                <a:gd name="connsiteY19" fmla="*/ 672358 h 996696"/>
                <a:gd name="connsiteX0" fmla="*/ 161529 w 1203322"/>
                <a:gd name="connsiteY0" fmla="*/ 708012 h 1032350"/>
                <a:gd name="connsiteX1" fmla="*/ 82399 w 1203322"/>
                <a:gd name="connsiteY1" fmla="*/ 804727 h 1032350"/>
                <a:gd name="connsiteX2" fmla="*/ 3268 w 1203322"/>
                <a:gd name="connsiteY2" fmla="*/ 690427 h 1032350"/>
                <a:gd name="connsiteX3" fmla="*/ 20853 w 1203322"/>
                <a:gd name="connsiteY3" fmla="*/ 523373 h 1032350"/>
                <a:gd name="connsiteX4" fmla="*/ 73606 w 1203322"/>
                <a:gd name="connsiteY4" fmla="*/ 294773 h 1032350"/>
                <a:gd name="connsiteX5" fmla="*/ 179114 w 1203322"/>
                <a:gd name="connsiteY5" fmla="*/ 171681 h 1032350"/>
                <a:gd name="connsiteX6" fmla="*/ 521050 w 1203322"/>
                <a:gd name="connsiteY6" fmla="*/ 7530 h 1032350"/>
                <a:gd name="connsiteX7" fmla="*/ 835556 w 1203322"/>
                <a:gd name="connsiteY7" fmla="*/ 37271 h 1032350"/>
                <a:gd name="connsiteX8" fmla="*/ 962033 w 1203322"/>
                <a:gd name="connsiteY8" fmla="*/ 123135 h 1032350"/>
                <a:gd name="connsiteX9" fmla="*/ 1075929 w 1203322"/>
                <a:gd name="connsiteY9" fmla="*/ 294773 h 1032350"/>
                <a:gd name="connsiteX10" fmla="*/ 1200520 w 1203322"/>
                <a:gd name="connsiteY10" fmla="*/ 539248 h 1032350"/>
                <a:gd name="connsiteX11" fmla="*/ 1155060 w 1203322"/>
                <a:gd name="connsiteY11" fmla="*/ 655258 h 1032350"/>
                <a:gd name="connsiteX12" fmla="*/ 1067137 w 1203322"/>
                <a:gd name="connsiteY12" fmla="*/ 795935 h 1032350"/>
                <a:gd name="connsiteX13" fmla="*/ 952837 w 1203322"/>
                <a:gd name="connsiteY13" fmla="*/ 919027 h 1032350"/>
                <a:gd name="connsiteX14" fmla="*/ 715445 w 1203322"/>
                <a:gd name="connsiteY14" fmla="*/ 1024535 h 1032350"/>
                <a:gd name="connsiteX15" fmla="*/ 486845 w 1203322"/>
                <a:gd name="connsiteY15" fmla="*/ 1024535 h 1032350"/>
                <a:gd name="connsiteX16" fmla="*/ 310999 w 1203322"/>
                <a:gd name="connsiteY16" fmla="*/ 1024535 h 1032350"/>
                <a:gd name="connsiteX17" fmla="*/ 187906 w 1203322"/>
                <a:gd name="connsiteY17" fmla="*/ 919027 h 1032350"/>
                <a:gd name="connsiteX18" fmla="*/ 249453 w 1203322"/>
                <a:gd name="connsiteY18" fmla="*/ 857481 h 1032350"/>
                <a:gd name="connsiteX19" fmla="*/ 161529 w 1203322"/>
                <a:gd name="connsiteY19" fmla="*/ 708012 h 1032350"/>
                <a:gd name="connsiteX0" fmla="*/ 161529 w 1203322"/>
                <a:gd name="connsiteY0" fmla="*/ 715453 h 1039791"/>
                <a:gd name="connsiteX1" fmla="*/ 82399 w 1203322"/>
                <a:gd name="connsiteY1" fmla="*/ 812168 h 1039791"/>
                <a:gd name="connsiteX2" fmla="*/ 3268 w 1203322"/>
                <a:gd name="connsiteY2" fmla="*/ 697868 h 1039791"/>
                <a:gd name="connsiteX3" fmla="*/ 20853 w 1203322"/>
                <a:gd name="connsiteY3" fmla="*/ 530814 h 1039791"/>
                <a:gd name="connsiteX4" fmla="*/ 73606 w 1203322"/>
                <a:gd name="connsiteY4" fmla="*/ 302214 h 1039791"/>
                <a:gd name="connsiteX5" fmla="*/ 179114 w 1203322"/>
                <a:gd name="connsiteY5" fmla="*/ 179122 h 1039791"/>
                <a:gd name="connsiteX6" fmla="*/ 521050 w 1203322"/>
                <a:gd name="connsiteY6" fmla="*/ 14971 h 1039791"/>
                <a:gd name="connsiteX7" fmla="*/ 798771 w 1203322"/>
                <a:gd name="connsiteY7" fmla="*/ 20627 h 1039791"/>
                <a:gd name="connsiteX8" fmla="*/ 962033 w 1203322"/>
                <a:gd name="connsiteY8" fmla="*/ 130576 h 1039791"/>
                <a:gd name="connsiteX9" fmla="*/ 1075929 w 1203322"/>
                <a:gd name="connsiteY9" fmla="*/ 302214 h 1039791"/>
                <a:gd name="connsiteX10" fmla="*/ 1200520 w 1203322"/>
                <a:gd name="connsiteY10" fmla="*/ 546689 h 1039791"/>
                <a:gd name="connsiteX11" fmla="*/ 1155060 w 1203322"/>
                <a:gd name="connsiteY11" fmla="*/ 662699 h 1039791"/>
                <a:gd name="connsiteX12" fmla="*/ 1067137 w 1203322"/>
                <a:gd name="connsiteY12" fmla="*/ 803376 h 1039791"/>
                <a:gd name="connsiteX13" fmla="*/ 952837 w 1203322"/>
                <a:gd name="connsiteY13" fmla="*/ 926468 h 1039791"/>
                <a:gd name="connsiteX14" fmla="*/ 715445 w 1203322"/>
                <a:gd name="connsiteY14" fmla="*/ 1031976 h 1039791"/>
                <a:gd name="connsiteX15" fmla="*/ 486845 w 1203322"/>
                <a:gd name="connsiteY15" fmla="*/ 1031976 h 1039791"/>
                <a:gd name="connsiteX16" fmla="*/ 310999 w 1203322"/>
                <a:gd name="connsiteY16" fmla="*/ 1031976 h 1039791"/>
                <a:gd name="connsiteX17" fmla="*/ 187906 w 1203322"/>
                <a:gd name="connsiteY17" fmla="*/ 926468 h 1039791"/>
                <a:gd name="connsiteX18" fmla="*/ 249453 w 1203322"/>
                <a:gd name="connsiteY18" fmla="*/ 864922 h 1039791"/>
                <a:gd name="connsiteX19" fmla="*/ 161529 w 1203322"/>
                <a:gd name="connsiteY19" fmla="*/ 715453 h 1039791"/>
                <a:gd name="connsiteX0" fmla="*/ 161529 w 1203322"/>
                <a:gd name="connsiteY0" fmla="*/ 715453 h 1039791"/>
                <a:gd name="connsiteX1" fmla="*/ 82399 w 1203322"/>
                <a:gd name="connsiteY1" fmla="*/ 812168 h 1039791"/>
                <a:gd name="connsiteX2" fmla="*/ 3268 w 1203322"/>
                <a:gd name="connsiteY2" fmla="*/ 697868 h 1039791"/>
                <a:gd name="connsiteX3" fmla="*/ 20853 w 1203322"/>
                <a:gd name="connsiteY3" fmla="*/ 530814 h 1039791"/>
                <a:gd name="connsiteX4" fmla="*/ 73606 w 1203322"/>
                <a:gd name="connsiteY4" fmla="*/ 302214 h 1039791"/>
                <a:gd name="connsiteX5" fmla="*/ 179114 w 1203322"/>
                <a:gd name="connsiteY5" fmla="*/ 179122 h 1039791"/>
                <a:gd name="connsiteX6" fmla="*/ 521050 w 1203322"/>
                <a:gd name="connsiteY6" fmla="*/ 14971 h 1039791"/>
                <a:gd name="connsiteX7" fmla="*/ 798771 w 1203322"/>
                <a:gd name="connsiteY7" fmla="*/ 20627 h 1039791"/>
                <a:gd name="connsiteX8" fmla="*/ 962033 w 1203322"/>
                <a:gd name="connsiteY8" fmla="*/ 130576 h 1039791"/>
                <a:gd name="connsiteX9" fmla="*/ 1075929 w 1203322"/>
                <a:gd name="connsiteY9" fmla="*/ 302214 h 1039791"/>
                <a:gd name="connsiteX10" fmla="*/ 1200520 w 1203322"/>
                <a:gd name="connsiteY10" fmla="*/ 546689 h 1039791"/>
                <a:gd name="connsiteX11" fmla="*/ 1155060 w 1203322"/>
                <a:gd name="connsiteY11" fmla="*/ 734951 h 1039791"/>
                <a:gd name="connsiteX12" fmla="*/ 1067137 w 1203322"/>
                <a:gd name="connsiteY12" fmla="*/ 803376 h 1039791"/>
                <a:gd name="connsiteX13" fmla="*/ 952837 w 1203322"/>
                <a:gd name="connsiteY13" fmla="*/ 926468 h 1039791"/>
                <a:gd name="connsiteX14" fmla="*/ 715445 w 1203322"/>
                <a:gd name="connsiteY14" fmla="*/ 1031976 h 1039791"/>
                <a:gd name="connsiteX15" fmla="*/ 486845 w 1203322"/>
                <a:gd name="connsiteY15" fmla="*/ 1031976 h 1039791"/>
                <a:gd name="connsiteX16" fmla="*/ 310999 w 1203322"/>
                <a:gd name="connsiteY16" fmla="*/ 1031976 h 1039791"/>
                <a:gd name="connsiteX17" fmla="*/ 187906 w 1203322"/>
                <a:gd name="connsiteY17" fmla="*/ 926468 h 1039791"/>
                <a:gd name="connsiteX18" fmla="*/ 249453 w 1203322"/>
                <a:gd name="connsiteY18" fmla="*/ 864922 h 1039791"/>
                <a:gd name="connsiteX19" fmla="*/ 161529 w 1203322"/>
                <a:gd name="connsiteY19" fmla="*/ 715453 h 1039791"/>
                <a:gd name="connsiteX0" fmla="*/ 161529 w 1205333"/>
                <a:gd name="connsiteY0" fmla="*/ 715453 h 1039791"/>
                <a:gd name="connsiteX1" fmla="*/ 82399 w 1205333"/>
                <a:gd name="connsiteY1" fmla="*/ 812168 h 1039791"/>
                <a:gd name="connsiteX2" fmla="*/ 3268 w 1205333"/>
                <a:gd name="connsiteY2" fmla="*/ 697868 h 1039791"/>
                <a:gd name="connsiteX3" fmla="*/ 20853 w 1205333"/>
                <a:gd name="connsiteY3" fmla="*/ 530814 h 1039791"/>
                <a:gd name="connsiteX4" fmla="*/ 73606 w 1205333"/>
                <a:gd name="connsiteY4" fmla="*/ 302214 h 1039791"/>
                <a:gd name="connsiteX5" fmla="*/ 179114 w 1205333"/>
                <a:gd name="connsiteY5" fmla="*/ 179122 h 1039791"/>
                <a:gd name="connsiteX6" fmla="*/ 521050 w 1205333"/>
                <a:gd name="connsiteY6" fmla="*/ 14971 h 1039791"/>
                <a:gd name="connsiteX7" fmla="*/ 798771 w 1205333"/>
                <a:gd name="connsiteY7" fmla="*/ 20627 h 1039791"/>
                <a:gd name="connsiteX8" fmla="*/ 962033 w 1205333"/>
                <a:gd name="connsiteY8" fmla="*/ 130576 h 1039791"/>
                <a:gd name="connsiteX9" fmla="*/ 1075929 w 1205333"/>
                <a:gd name="connsiteY9" fmla="*/ 302214 h 1039791"/>
                <a:gd name="connsiteX10" fmla="*/ 1200520 w 1205333"/>
                <a:gd name="connsiteY10" fmla="*/ 546689 h 1039791"/>
                <a:gd name="connsiteX11" fmla="*/ 1168854 w 1205333"/>
                <a:gd name="connsiteY11" fmla="*/ 686782 h 1039791"/>
                <a:gd name="connsiteX12" fmla="*/ 1067137 w 1205333"/>
                <a:gd name="connsiteY12" fmla="*/ 803376 h 1039791"/>
                <a:gd name="connsiteX13" fmla="*/ 952837 w 1205333"/>
                <a:gd name="connsiteY13" fmla="*/ 926468 h 1039791"/>
                <a:gd name="connsiteX14" fmla="*/ 715445 w 1205333"/>
                <a:gd name="connsiteY14" fmla="*/ 1031976 h 1039791"/>
                <a:gd name="connsiteX15" fmla="*/ 486845 w 1205333"/>
                <a:gd name="connsiteY15" fmla="*/ 1031976 h 1039791"/>
                <a:gd name="connsiteX16" fmla="*/ 310999 w 1205333"/>
                <a:gd name="connsiteY16" fmla="*/ 1031976 h 1039791"/>
                <a:gd name="connsiteX17" fmla="*/ 187906 w 1205333"/>
                <a:gd name="connsiteY17" fmla="*/ 926468 h 1039791"/>
                <a:gd name="connsiteX18" fmla="*/ 249453 w 1205333"/>
                <a:gd name="connsiteY18" fmla="*/ 864922 h 1039791"/>
                <a:gd name="connsiteX19" fmla="*/ 161529 w 1205333"/>
                <a:gd name="connsiteY19" fmla="*/ 715453 h 1039791"/>
                <a:gd name="connsiteX0" fmla="*/ 161529 w 1204941"/>
                <a:gd name="connsiteY0" fmla="*/ 715453 h 1039791"/>
                <a:gd name="connsiteX1" fmla="*/ 82399 w 1204941"/>
                <a:gd name="connsiteY1" fmla="*/ 812168 h 1039791"/>
                <a:gd name="connsiteX2" fmla="*/ 3268 w 1204941"/>
                <a:gd name="connsiteY2" fmla="*/ 697868 h 1039791"/>
                <a:gd name="connsiteX3" fmla="*/ 20853 w 1204941"/>
                <a:gd name="connsiteY3" fmla="*/ 530814 h 1039791"/>
                <a:gd name="connsiteX4" fmla="*/ 73606 w 1204941"/>
                <a:gd name="connsiteY4" fmla="*/ 302214 h 1039791"/>
                <a:gd name="connsiteX5" fmla="*/ 179114 w 1204941"/>
                <a:gd name="connsiteY5" fmla="*/ 179122 h 1039791"/>
                <a:gd name="connsiteX6" fmla="*/ 521050 w 1204941"/>
                <a:gd name="connsiteY6" fmla="*/ 14971 h 1039791"/>
                <a:gd name="connsiteX7" fmla="*/ 798771 w 1204941"/>
                <a:gd name="connsiteY7" fmla="*/ 20627 h 1039791"/>
                <a:gd name="connsiteX8" fmla="*/ 962033 w 1204941"/>
                <a:gd name="connsiteY8" fmla="*/ 130576 h 1039791"/>
                <a:gd name="connsiteX9" fmla="*/ 1075929 w 1204941"/>
                <a:gd name="connsiteY9" fmla="*/ 302214 h 1039791"/>
                <a:gd name="connsiteX10" fmla="*/ 1200520 w 1204941"/>
                <a:gd name="connsiteY10" fmla="*/ 546689 h 1039791"/>
                <a:gd name="connsiteX11" fmla="*/ 1168854 w 1204941"/>
                <a:gd name="connsiteY11" fmla="*/ 686782 h 1039791"/>
                <a:gd name="connsiteX12" fmla="*/ 1090128 w 1204941"/>
                <a:gd name="connsiteY12" fmla="*/ 832277 h 1039791"/>
                <a:gd name="connsiteX13" fmla="*/ 952837 w 1204941"/>
                <a:gd name="connsiteY13" fmla="*/ 926468 h 1039791"/>
                <a:gd name="connsiteX14" fmla="*/ 715445 w 1204941"/>
                <a:gd name="connsiteY14" fmla="*/ 1031976 h 1039791"/>
                <a:gd name="connsiteX15" fmla="*/ 486845 w 1204941"/>
                <a:gd name="connsiteY15" fmla="*/ 1031976 h 1039791"/>
                <a:gd name="connsiteX16" fmla="*/ 310999 w 1204941"/>
                <a:gd name="connsiteY16" fmla="*/ 1031976 h 1039791"/>
                <a:gd name="connsiteX17" fmla="*/ 187906 w 1204941"/>
                <a:gd name="connsiteY17" fmla="*/ 926468 h 1039791"/>
                <a:gd name="connsiteX18" fmla="*/ 249453 w 1204941"/>
                <a:gd name="connsiteY18" fmla="*/ 864922 h 1039791"/>
                <a:gd name="connsiteX19" fmla="*/ 161529 w 1204941"/>
                <a:gd name="connsiteY19" fmla="*/ 715453 h 1039791"/>
                <a:gd name="connsiteX0" fmla="*/ 161529 w 1207981"/>
                <a:gd name="connsiteY0" fmla="*/ 715453 h 1039791"/>
                <a:gd name="connsiteX1" fmla="*/ 82399 w 1207981"/>
                <a:gd name="connsiteY1" fmla="*/ 812168 h 1039791"/>
                <a:gd name="connsiteX2" fmla="*/ 3268 w 1207981"/>
                <a:gd name="connsiteY2" fmla="*/ 697868 h 1039791"/>
                <a:gd name="connsiteX3" fmla="*/ 20853 w 1207981"/>
                <a:gd name="connsiteY3" fmla="*/ 530814 h 1039791"/>
                <a:gd name="connsiteX4" fmla="*/ 73606 w 1207981"/>
                <a:gd name="connsiteY4" fmla="*/ 302214 h 1039791"/>
                <a:gd name="connsiteX5" fmla="*/ 179114 w 1207981"/>
                <a:gd name="connsiteY5" fmla="*/ 179122 h 1039791"/>
                <a:gd name="connsiteX6" fmla="*/ 521050 w 1207981"/>
                <a:gd name="connsiteY6" fmla="*/ 14971 h 1039791"/>
                <a:gd name="connsiteX7" fmla="*/ 798771 w 1207981"/>
                <a:gd name="connsiteY7" fmla="*/ 20627 h 1039791"/>
                <a:gd name="connsiteX8" fmla="*/ 962033 w 1207981"/>
                <a:gd name="connsiteY8" fmla="*/ 130576 h 1039791"/>
                <a:gd name="connsiteX9" fmla="*/ 1075929 w 1207981"/>
                <a:gd name="connsiteY9" fmla="*/ 302214 h 1039791"/>
                <a:gd name="connsiteX10" fmla="*/ 1200520 w 1207981"/>
                <a:gd name="connsiteY10" fmla="*/ 546689 h 1039791"/>
                <a:gd name="connsiteX11" fmla="*/ 1182648 w 1207981"/>
                <a:gd name="connsiteY11" fmla="*/ 710866 h 1039791"/>
                <a:gd name="connsiteX12" fmla="*/ 1090128 w 1207981"/>
                <a:gd name="connsiteY12" fmla="*/ 832277 h 1039791"/>
                <a:gd name="connsiteX13" fmla="*/ 952837 w 1207981"/>
                <a:gd name="connsiteY13" fmla="*/ 926468 h 1039791"/>
                <a:gd name="connsiteX14" fmla="*/ 715445 w 1207981"/>
                <a:gd name="connsiteY14" fmla="*/ 1031976 h 1039791"/>
                <a:gd name="connsiteX15" fmla="*/ 486845 w 1207981"/>
                <a:gd name="connsiteY15" fmla="*/ 1031976 h 1039791"/>
                <a:gd name="connsiteX16" fmla="*/ 310999 w 1207981"/>
                <a:gd name="connsiteY16" fmla="*/ 1031976 h 1039791"/>
                <a:gd name="connsiteX17" fmla="*/ 187906 w 1207981"/>
                <a:gd name="connsiteY17" fmla="*/ 926468 h 1039791"/>
                <a:gd name="connsiteX18" fmla="*/ 249453 w 1207981"/>
                <a:gd name="connsiteY18" fmla="*/ 864922 h 1039791"/>
                <a:gd name="connsiteX19" fmla="*/ 161529 w 1207981"/>
                <a:gd name="connsiteY19" fmla="*/ 715453 h 1039791"/>
                <a:gd name="connsiteX0" fmla="*/ 161529 w 1211826"/>
                <a:gd name="connsiteY0" fmla="*/ 715453 h 1039791"/>
                <a:gd name="connsiteX1" fmla="*/ 82399 w 1211826"/>
                <a:gd name="connsiteY1" fmla="*/ 812168 h 1039791"/>
                <a:gd name="connsiteX2" fmla="*/ 3268 w 1211826"/>
                <a:gd name="connsiteY2" fmla="*/ 697868 h 1039791"/>
                <a:gd name="connsiteX3" fmla="*/ 20853 w 1211826"/>
                <a:gd name="connsiteY3" fmla="*/ 530814 h 1039791"/>
                <a:gd name="connsiteX4" fmla="*/ 73606 w 1211826"/>
                <a:gd name="connsiteY4" fmla="*/ 302214 h 1039791"/>
                <a:gd name="connsiteX5" fmla="*/ 179114 w 1211826"/>
                <a:gd name="connsiteY5" fmla="*/ 179122 h 1039791"/>
                <a:gd name="connsiteX6" fmla="*/ 521050 w 1211826"/>
                <a:gd name="connsiteY6" fmla="*/ 14971 h 1039791"/>
                <a:gd name="connsiteX7" fmla="*/ 798771 w 1211826"/>
                <a:gd name="connsiteY7" fmla="*/ 20627 h 1039791"/>
                <a:gd name="connsiteX8" fmla="*/ 962033 w 1211826"/>
                <a:gd name="connsiteY8" fmla="*/ 130576 h 1039791"/>
                <a:gd name="connsiteX9" fmla="*/ 1075929 w 1211826"/>
                <a:gd name="connsiteY9" fmla="*/ 302214 h 1039791"/>
                <a:gd name="connsiteX10" fmla="*/ 1205118 w 1211826"/>
                <a:gd name="connsiteY10" fmla="*/ 580407 h 1039791"/>
                <a:gd name="connsiteX11" fmla="*/ 1182648 w 1211826"/>
                <a:gd name="connsiteY11" fmla="*/ 710866 h 1039791"/>
                <a:gd name="connsiteX12" fmla="*/ 1090128 w 1211826"/>
                <a:gd name="connsiteY12" fmla="*/ 832277 h 1039791"/>
                <a:gd name="connsiteX13" fmla="*/ 952837 w 1211826"/>
                <a:gd name="connsiteY13" fmla="*/ 926468 h 1039791"/>
                <a:gd name="connsiteX14" fmla="*/ 715445 w 1211826"/>
                <a:gd name="connsiteY14" fmla="*/ 1031976 h 1039791"/>
                <a:gd name="connsiteX15" fmla="*/ 486845 w 1211826"/>
                <a:gd name="connsiteY15" fmla="*/ 1031976 h 1039791"/>
                <a:gd name="connsiteX16" fmla="*/ 310999 w 1211826"/>
                <a:gd name="connsiteY16" fmla="*/ 1031976 h 1039791"/>
                <a:gd name="connsiteX17" fmla="*/ 187906 w 1211826"/>
                <a:gd name="connsiteY17" fmla="*/ 926468 h 1039791"/>
                <a:gd name="connsiteX18" fmla="*/ 249453 w 1211826"/>
                <a:gd name="connsiteY18" fmla="*/ 864922 h 1039791"/>
                <a:gd name="connsiteX19" fmla="*/ 161529 w 1211826"/>
                <a:gd name="connsiteY19" fmla="*/ 715453 h 1039791"/>
                <a:gd name="connsiteX0" fmla="*/ 161529 w 1208901"/>
                <a:gd name="connsiteY0" fmla="*/ 715453 h 1039791"/>
                <a:gd name="connsiteX1" fmla="*/ 82399 w 1208901"/>
                <a:gd name="connsiteY1" fmla="*/ 812168 h 1039791"/>
                <a:gd name="connsiteX2" fmla="*/ 3268 w 1208901"/>
                <a:gd name="connsiteY2" fmla="*/ 697868 h 1039791"/>
                <a:gd name="connsiteX3" fmla="*/ 20853 w 1208901"/>
                <a:gd name="connsiteY3" fmla="*/ 530814 h 1039791"/>
                <a:gd name="connsiteX4" fmla="*/ 73606 w 1208901"/>
                <a:gd name="connsiteY4" fmla="*/ 302214 h 1039791"/>
                <a:gd name="connsiteX5" fmla="*/ 179114 w 1208901"/>
                <a:gd name="connsiteY5" fmla="*/ 179122 h 1039791"/>
                <a:gd name="connsiteX6" fmla="*/ 521050 w 1208901"/>
                <a:gd name="connsiteY6" fmla="*/ 14971 h 1039791"/>
                <a:gd name="connsiteX7" fmla="*/ 798771 w 1208901"/>
                <a:gd name="connsiteY7" fmla="*/ 20627 h 1039791"/>
                <a:gd name="connsiteX8" fmla="*/ 962033 w 1208901"/>
                <a:gd name="connsiteY8" fmla="*/ 130576 h 1039791"/>
                <a:gd name="connsiteX9" fmla="*/ 1117312 w 1208901"/>
                <a:gd name="connsiteY9" fmla="*/ 345566 h 1039791"/>
                <a:gd name="connsiteX10" fmla="*/ 1205118 w 1208901"/>
                <a:gd name="connsiteY10" fmla="*/ 580407 h 1039791"/>
                <a:gd name="connsiteX11" fmla="*/ 1182648 w 1208901"/>
                <a:gd name="connsiteY11" fmla="*/ 710866 h 1039791"/>
                <a:gd name="connsiteX12" fmla="*/ 1090128 w 1208901"/>
                <a:gd name="connsiteY12" fmla="*/ 832277 h 1039791"/>
                <a:gd name="connsiteX13" fmla="*/ 952837 w 1208901"/>
                <a:gd name="connsiteY13" fmla="*/ 926468 h 1039791"/>
                <a:gd name="connsiteX14" fmla="*/ 715445 w 1208901"/>
                <a:gd name="connsiteY14" fmla="*/ 1031976 h 1039791"/>
                <a:gd name="connsiteX15" fmla="*/ 486845 w 1208901"/>
                <a:gd name="connsiteY15" fmla="*/ 1031976 h 1039791"/>
                <a:gd name="connsiteX16" fmla="*/ 310999 w 1208901"/>
                <a:gd name="connsiteY16" fmla="*/ 1031976 h 1039791"/>
                <a:gd name="connsiteX17" fmla="*/ 187906 w 1208901"/>
                <a:gd name="connsiteY17" fmla="*/ 926468 h 1039791"/>
                <a:gd name="connsiteX18" fmla="*/ 249453 w 1208901"/>
                <a:gd name="connsiteY18" fmla="*/ 864922 h 1039791"/>
                <a:gd name="connsiteX19" fmla="*/ 161529 w 1208901"/>
                <a:gd name="connsiteY19" fmla="*/ 715453 h 1039791"/>
                <a:gd name="connsiteX0" fmla="*/ 161529 w 1208901"/>
                <a:gd name="connsiteY0" fmla="*/ 715453 h 1057552"/>
                <a:gd name="connsiteX1" fmla="*/ 82399 w 1208901"/>
                <a:gd name="connsiteY1" fmla="*/ 812168 h 1057552"/>
                <a:gd name="connsiteX2" fmla="*/ 3268 w 1208901"/>
                <a:gd name="connsiteY2" fmla="*/ 697868 h 1057552"/>
                <a:gd name="connsiteX3" fmla="*/ 20853 w 1208901"/>
                <a:gd name="connsiteY3" fmla="*/ 530814 h 1057552"/>
                <a:gd name="connsiteX4" fmla="*/ 73606 w 1208901"/>
                <a:gd name="connsiteY4" fmla="*/ 302214 h 1057552"/>
                <a:gd name="connsiteX5" fmla="*/ 179114 w 1208901"/>
                <a:gd name="connsiteY5" fmla="*/ 179122 h 1057552"/>
                <a:gd name="connsiteX6" fmla="*/ 521050 w 1208901"/>
                <a:gd name="connsiteY6" fmla="*/ 14971 h 1057552"/>
                <a:gd name="connsiteX7" fmla="*/ 798771 w 1208901"/>
                <a:gd name="connsiteY7" fmla="*/ 20627 h 1057552"/>
                <a:gd name="connsiteX8" fmla="*/ 962033 w 1208901"/>
                <a:gd name="connsiteY8" fmla="*/ 130576 h 1057552"/>
                <a:gd name="connsiteX9" fmla="*/ 1117312 w 1208901"/>
                <a:gd name="connsiteY9" fmla="*/ 345566 h 1057552"/>
                <a:gd name="connsiteX10" fmla="*/ 1205118 w 1208901"/>
                <a:gd name="connsiteY10" fmla="*/ 580407 h 1057552"/>
                <a:gd name="connsiteX11" fmla="*/ 1182648 w 1208901"/>
                <a:gd name="connsiteY11" fmla="*/ 710866 h 1057552"/>
                <a:gd name="connsiteX12" fmla="*/ 1090128 w 1208901"/>
                <a:gd name="connsiteY12" fmla="*/ 832277 h 1057552"/>
                <a:gd name="connsiteX13" fmla="*/ 952837 w 1208901"/>
                <a:gd name="connsiteY13" fmla="*/ 926468 h 1057552"/>
                <a:gd name="connsiteX14" fmla="*/ 715445 w 1208901"/>
                <a:gd name="connsiteY14" fmla="*/ 1031976 h 1057552"/>
                <a:gd name="connsiteX15" fmla="*/ 551949 w 1208901"/>
                <a:gd name="connsiteY15" fmla="*/ 1057552 h 1057552"/>
                <a:gd name="connsiteX16" fmla="*/ 310999 w 1208901"/>
                <a:gd name="connsiteY16" fmla="*/ 1031976 h 1057552"/>
                <a:gd name="connsiteX17" fmla="*/ 187906 w 1208901"/>
                <a:gd name="connsiteY17" fmla="*/ 926468 h 1057552"/>
                <a:gd name="connsiteX18" fmla="*/ 249453 w 1208901"/>
                <a:gd name="connsiteY18" fmla="*/ 864922 h 1057552"/>
                <a:gd name="connsiteX19" fmla="*/ 161529 w 1208901"/>
                <a:gd name="connsiteY19" fmla="*/ 715453 h 1057552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</a:cxnLst>
              <a:rect l="l" t="t" r="r" b="b"/>
              <a:pathLst>
                <a:path w="1208901" h="1057552">
                  <a:moveTo>
                    <a:pt x="161529" y="715453"/>
                  </a:moveTo>
                  <a:cubicBezTo>
                    <a:pt x="133687" y="706661"/>
                    <a:pt x="108776" y="815099"/>
                    <a:pt x="82399" y="812168"/>
                  </a:cubicBezTo>
                  <a:cubicBezTo>
                    <a:pt x="56022" y="809237"/>
                    <a:pt x="13526" y="744760"/>
                    <a:pt x="3268" y="697868"/>
                  </a:cubicBezTo>
                  <a:cubicBezTo>
                    <a:pt x="-6990" y="650976"/>
                    <a:pt x="9130" y="596756"/>
                    <a:pt x="20853" y="530814"/>
                  </a:cubicBezTo>
                  <a:cubicBezTo>
                    <a:pt x="32576" y="464872"/>
                    <a:pt x="47229" y="360829"/>
                    <a:pt x="73606" y="302214"/>
                  </a:cubicBezTo>
                  <a:cubicBezTo>
                    <a:pt x="99983" y="243599"/>
                    <a:pt x="104540" y="226996"/>
                    <a:pt x="179114" y="179122"/>
                  </a:cubicBezTo>
                  <a:cubicBezTo>
                    <a:pt x="253688" y="131248"/>
                    <a:pt x="417774" y="41387"/>
                    <a:pt x="521050" y="14971"/>
                  </a:cubicBezTo>
                  <a:cubicBezTo>
                    <a:pt x="624326" y="-11445"/>
                    <a:pt x="725274" y="1360"/>
                    <a:pt x="798771" y="20627"/>
                  </a:cubicBezTo>
                  <a:cubicBezTo>
                    <a:pt x="872268" y="39894"/>
                    <a:pt x="908943" y="76420"/>
                    <a:pt x="962033" y="130576"/>
                  </a:cubicBezTo>
                  <a:cubicBezTo>
                    <a:pt x="1015123" y="184732"/>
                    <a:pt x="1076798" y="270594"/>
                    <a:pt x="1117312" y="345566"/>
                  </a:cubicBezTo>
                  <a:cubicBezTo>
                    <a:pt x="1157826" y="420538"/>
                    <a:pt x="1194229" y="519524"/>
                    <a:pt x="1205118" y="580407"/>
                  </a:cubicBezTo>
                  <a:cubicBezTo>
                    <a:pt x="1216007" y="641290"/>
                    <a:pt x="1201813" y="668888"/>
                    <a:pt x="1182648" y="710866"/>
                  </a:cubicBezTo>
                  <a:cubicBezTo>
                    <a:pt x="1163483" y="752844"/>
                    <a:pt x="1128430" y="796343"/>
                    <a:pt x="1090128" y="832277"/>
                  </a:cubicBezTo>
                  <a:cubicBezTo>
                    <a:pt x="1051826" y="868211"/>
                    <a:pt x="1015284" y="893185"/>
                    <a:pt x="952837" y="926468"/>
                  </a:cubicBezTo>
                  <a:cubicBezTo>
                    <a:pt x="890390" y="959751"/>
                    <a:pt x="782260" y="1010129"/>
                    <a:pt x="715445" y="1031976"/>
                  </a:cubicBezTo>
                  <a:cubicBezTo>
                    <a:pt x="648630" y="1053823"/>
                    <a:pt x="551949" y="1057552"/>
                    <a:pt x="551949" y="1057552"/>
                  </a:cubicBezTo>
                  <a:cubicBezTo>
                    <a:pt x="484541" y="1057552"/>
                    <a:pt x="371673" y="1053823"/>
                    <a:pt x="310999" y="1031976"/>
                  </a:cubicBezTo>
                  <a:cubicBezTo>
                    <a:pt x="250325" y="1010129"/>
                    <a:pt x="198164" y="954310"/>
                    <a:pt x="187906" y="926468"/>
                  </a:cubicBezTo>
                  <a:cubicBezTo>
                    <a:pt x="177648" y="898626"/>
                    <a:pt x="246522" y="900091"/>
                    <a:pt x="249453" y="864922"/>
                  </a:cubicBezTo>
                  <a:cubicBezTo>
                    <a:pt x="252384" y="829753"/>
                    <a:pt x="189371" y="724245"/>
                    <a:pt x="161529" y="715453"/>
                  </a:cubicBezTo>
                  <a:close/>
                </a:path>
              </a:pathLst>
            </a:custGeom>
            <a:solidFill>
              <a:schemeClr val="accent2">
                <a:lumMod val="60000"/>
                <a:lumOff val="40000"/>
              </a:schemeClr>
            </a:solidFill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7" name="フリーフォーム 16">
              <a:extLst>
                <a:ext uri="{FF2B5EF4-FFF2-40B4-BE49-F238E27FC236}">
                  <a16:creationId xmlns:a16="http://schemas.microsoft.com/office/drawing/2014/main" id="{42136784-EC4F-9067-1764-A8E0614D7FD1}"/>
                </a:ext>
              </a:extLst>
            </p:cNvPr>
            <p:cNvSpPr/>
            <p:nvPr/>
          </p:nvSpPr>
          <p:spPr>
            <a:xfrm rot="20238476">
              <a:off x="6812759" y="3501622"/>
              <a:ext cx="704434" cy="678462"/>
            </a:xfrm>
            <a:custGeom>
              <a:avLst/>
              <a:gdLst>
                <a:gd name="connsiteX0" fmla="*/ 405532 w 704876"/>
                <a:gd name="connsiteY0" fmla="*/ 5637 h 748021"/>
                <a:gd name="connsiteX1" fmla="*/ 586602 w 704876"/>
                <a:gd name="connsiteY1" fmla="*/ 114278 h 748021"/>
                <a:gd name="connsiteX2" fmla="*/ 695243 w 704876"/>
                <a:gd name="connsiteY2" fmla="*/ 304401 h 748021"/>
                <a:gd name="connsiteX3" fmla="*/ 686190 w 704876"/>
                <a:gd name="connsiteY3" fmla="*/ 394936 h 748021"/>
                <a:gd name="connsiteX4" fmla="*/ 577548 w 704876"/>
                <a:gd name="connsiteY4" fmla="*/ 621272 h 748021"/>
                <a:gd name="connsiteX5" fmla="*/ 179196 w 704876"/>
                <a:gd name="connsiteY5" fmla="*/ 748021 h 748021"/>
                <a:gd name="connsiteX6" fmla="*/ 16233 w 704876"/>
                <a:gd name="connsiteY6" fmla="*/ 621272 h 748021"/>
                <a:gd name="connsiteX7" fmla="*/ 25287 w 704876"/>
                <a:gd name="connsiteY7" fmla="*/ 431150 h 748021"/>
                <a:gd name="connsiteX8" fmla="*/ 188249 w 704876"/>
                <a:gd name="connsiteY8" fmla="*/ 204813 h 748021"/>
                <a:gd name="connsiteX9" fmla="*/ 242570 w 704876"/>
                <a:gd name="connsiteY9" fmla="*/ 259134 h 748021"/>
                <a:gd name="connsiteX10" fmla="*/ 260677 w 704876"/>
                <a:gd name="connsiteY10" fmla="*/ 467363 h 748021"/>
                <a:gd name="connsiteX11" fmla="*/ 378372 w 704876"/>
                <a:gd name="connsiteY11" fmla="*/ 286294 h 748021"/>
                <a:gd name="connsiteX12" fmla="*/ 405532 w 704876"/>
                <a:gd name="connsiteY12" fmla="*/ 5637 h 748021"/>
                <a:gd name="connsiteX0" fmla="*/ 405532 w 690128"/>
                <a:gd name="connsiteY0" fmla="*/ 5545 h 747929"/>
                <a:gd name="connsiteX1" fmla="*/ 586602 w 690128"/>
                <a:gd name="connsiteY1" fmla="*/ 114186 h 747929"/>
                <a:gd name="connsiteX2" fmla="*/ 658754 w 690128"/>
                <a:gd name="connsiteY2" fmla="*/ 292433 h 747929"/>
                <a:gd name="connsiteX3" fmla="*/ 686190 w 690128"/>
                <a:gd name="connsiteY3" fmla="*/ 394844 h 747929"/>
                <a:gd name="connsiteX4" fmla="*/ 577548 w 690128"/>
                <a:gd name="connsiteY4" fmla="*/ 621180 h 747929"/>
                <a:gd name="connsiteX5" fmla="*/ 179196 w 690128"/>
                <a:gd name="connsiteY5" fmla="*/ 747929 h 747929"/>
                <a:gd name="connsiteX6" fmla="*/ 16233 w 690128"/>
                <a:gd name="connsiteY6" fmla="*/ 621180 h 747929"/>
                <a:gd name="connsiteX7" fmla="*/ 25287 w 690128"/>
                <a:gd name="connsiteY7" fmla="*/ 431058 h 747929"/>
                <a:gd name="connsiteX8" fmla="*/ 188249 w 690128"/>
                <a:gd name="connsiteY8" fmla="*/ 204721 h 747929"/>
                <a:gd name="connsiteX9" fmla="*/ 242570 w 690128"/>
                <a:gd name="connsiteY9" fmla="*/ 259042 h 747929"/>
                <a:gd name="connsiteX10" fmla="*/ 260677 w 690128"/>
                <a:gd name="connsiteY10" fmla="*/ 467271 h 747929"/>
                <a:gd name="connsiteX11" fmla="*/ 378372 w 690128"/>
                <a:gd name="connsiteY11" fmla="*/ 286202 h 747929"/>
                <a:gd name="connsiteX12" fmla="*/ 405532 w 690128"/>
                <a:gd name="connsiteY12" fmla="*/ 5545 h 747929"/>
                <a:gd name="connsiteX0" fmla="*/ 399830 w 684426"/>
                <a:gd name="connsiteY0" fmla="*/ 5545 h 747929"/>
                <a:gd name="connsiteX1" fmla="*/ 580900 w 684426"/>
                <a:gd name="connsiteY1" fmla="*/ 114186 h 747929"/>
                <a:gd name="connsiteX2" fmla="*/ 653052 w 684426"/>
                <a:gd name="connsiteY2" fmla="*/ 292433 h 747929"/>
                <a:gd name="connsiteX3" fmla="*/ 680488 w 684426"/>
                <a:gd name="connsiteY3" fmla="*/ 394844 h 747929"/>
                <a:gd name="connsiteX4" fmla="*/ 571846 w 684426"/>
                <a:gd name="connsiteY4" fmla="*/ 621180 h 747929"/>
                <a:gd name="connsiteX5" fmla="*/ 173494 w 684426"/>
                <a:gd name="connsiteY5" fmla="*/ 747929 h 747929"/>
                <a:gd name="connsiteX6" fmla="*/ 10531 w 684426"/>
                <a:gd name="connsiteY6" fmla="*/ 621180 h 747929"/>
                <a:gd name="connsiteX7" fmla="*/ 34342 w 684426"/>
                <a:gd name="connsiteY7" fmla="*/ 438789 h 747929"/>
                <a:gd name="connsiteX8" fmla="*/ 182547 w 684426"/>
                <a:gd name="connsiteY8" fmla="*/ 204721 h 747929"/>
                <a:gd name="connsiteX9" fmla="*/ 236868 w 684426"/>
                <a:gd name="connsiteY9" fmla="*/ 259042 h 747929"/>
                <a:gd name="connsiteX10" fmla="*/ 254975 w 684426"/>
                <a:gd name="connsiteY10" fmla="*/ 467271 h 747929"/>
                <a:gd name="connsiteX11" fmla="*/ 372670 w 684426"/>
                <a:gd name="connsiteY11" fmla="*/ 286202 h 747929"/>
                <a:gd name="connsiteX12" fmla="*/ 399830 w 684426"/>
                <a:gd name="connsiteY12" fmla="*/ 5545 h 747929"/>
                <a:gd name="connsiteX0" fmla="*/ 374610 w 659206"/>
                <a:gd name="connsiteY0" fmla="*/ 5545 h 748546"/>
                <a:gd name="connsiteX1" fmla="*/ 555680 w 659206"/>
                <a:gd name="connsiteY1" fmla="*/ 114186 h 748546"/>
                <a:gd name="connsiteX2" fmla="*/ 627832 w 659206"/>
                <a:gd name="connsiteY2" fmla="*/ 292433 h 748546"/>
                <a:gd name="connsiteX3" fmla="*/ 655268 w 659206"/>
                <a:gd name="connsiteY3" fmla="*/ 394844 h 748546"/>
                <a:gd name="connsiteX4" fmla="*/ 546626 w 659206"/>
                <a:gd name="connsiteY4" fmla="*/ 621180 h 748546"/>
                <a:gd name="connsiteX5" fmla="*/ 148274 w 659206"/>
                <a:gd name="connsiteY5" fmla="*/ 747929 h 748546"/>
                <a:gd name="connsiteX6" fmla="*/ 30385 w 659206"/>
                <a:gd name="connsiteY6" fmla="*/ 659275 h 748546"/>
                <a:gd name="connsiteX7" fmla="*/ 9122 w 659206"/>
                <a:gd name="connsiteY7" fmla="*/ 438789 h 748546"/>
                <a:gd name="connsiteX8" fmla="*/ 157327 w 659206"/>
                <a:gd name="connsiteY8" fmla="*/ 204721 h 748546"/>
                <a:gd name="connsiteX9" fmla="*/ 211648 w 659206"/>
                <a:gd name="connsiteY9" fmla="*/ 259042 h 748546"/>
                <a:gd name="connsiteX10" fmla="*/ 229755 w 659206"/>
                <a:gd name="connsiteY10" fmla="*/ 467271 h 748546"/>
                <a:gd name="connsiteX11" fmla="*/ 347450 w 659206"/>
                <a:gd name="connsiteY11" fmla="*/ 286202 h 748546"/>
                <a:gd name="connsiteX12" fmla="*/ 374610 w 659206"/>
                <a:gd name="connsiteY12" fmla="*/ 5545 h 748546"/>
                <a:gd name="connsiteX0" fmla="*/ 377746 w 662342"/>
                <a:gd name="connsiteY0" fmla="*/ 5545 h 747656"/>
                <a:gd name="connsiteX1" fmla="*/ 558816 w 662342"/>
                <a:gd name="connsiteY1" fmla="*/ 114186 h 747656"/>
                <a:gd name="connsiteX2" fmla="*/ 630968 w 662342"/>
                <a:gd name="connsiteY2" fmla="*/ 292433 h 747656"/>
                <a:gd name="connsiteX3" fmla="*/ 658404 w 662342"/>
                <a:gd name="connsiteY3" fmla="*/ 394844 h 747656"/>
                <a:gd name="connsiteX4" fmla="*/ 549762 w 662342"/>
                <a:gd name="connsiteY4" fmla="*/ 621180 h 747656"/>
                <a:gd name="connsiteX5" fmla="*/ 232616 w 662342"/>
                <a:gd name="connsiteY5" fmla="*/ 747029 h 747656"/>
                <a:gd name="connsiteX6" fmla="*/ 33521 w 662342"/>
                <a:gd name="connsiteY6" fmla="*/ 659275 h 747656"/>
                <a:gd name="connsiteX7" fmla="*/ 12258 w 662342"/>
                <a:gd name="connsiteY7" fmla="*/ 438789 h 747656"/>
                <a:gd name="connsiteX8" fmla="*/ 160463 w 662342"/>
                <a:gd name="connsiteY8" fmla="*/ 204721 h 747656"/>
                <a:gd name="connsiteX9" fmla="*/ 214784 w 662342"/>
                <a:gd name="connsiteY9" fmla="*/ 259042 h 747656"/>
                <a:gd name="connsiteX10" fmla="*/ 232891 w 662342"/>
                <a:gd name="connsiteY10" fmla="*/ 467271 h 747656"/>
                <a:gd name="connsiteX11" fmla="*/ 350586 w 662342"/>
                <a:gd name="connsiteY11" fmla="*/ 286202 h 747656"/>
                <a:gd name="connsiteX12" fmla="*/ 377746 w 662342"/>
                <a:gd name="connsiteY12" fmla="*/ 5545 h 747656"/>
                <a:gd name="connsiteX0" fmla="*/ 377746 w 662029"/>
                <a:gd name="connsiteY0" fmla="*/ 5286 h 747397"/>
                <a:gd name="connsiteX1" fmla="*/ 558816 w 662029"/>
                <a:gd name="connsiteY1" fmla="*/ 113927 h 747397"/>
                <a:gd name="connsiteX2" fmla="*/ 629076 w 662029"/>
                <a:gd name="connsiteY2" fmla="*/ 257159 h 747397"/>
                <a:gd name="connsiteX3" fmla="*/ 658404 w 662029"/>
                <a:gd name="connsiteY3" fmla="*/ 394585 h 747397"/>
                <a:gd name="connsiteX4" fmla="*/ 549762 w 662029"/>
                <a:gd name="connsiteY4" fmla="*/ 620921 h 747397"/>
                <a:gd name="connsiteX5" fmla="*/ 232616 w 662029"/>
                <a:gd name="connsiteY5" fmla="*/ 746770 h 747397"/>
                <a:gd name="connsiteX6" fmla="*/ 33521 w 662029"/>
                <a:gd name="connsiteY6" fmla="*/ 659016 h 747397"/>
                <a:gd name="connsiteX7" fmla="*/ 12258 w 662029"/>
                <a:gd name="connsiteY7" fmla="*/ 438530 h 747397"/>
                <a:gd name="connsiteX8" fmla="*/ 160463 w 662029"/>
                <a:gd name="connsiteY8" fmla="*/ 204462 h 747397"/>
                <a:gd name="connsiteX9" fmla="*/ 214784 w 662029"/>
                <a:gd name="connsiteY9" fmla="*/ 258783 h 747397"/>
                <a:gd name="connsiteX10" fmla="*/ 232891 w 662029"/>
                <a:gd name="connsiteY10" fmla="*/ 467012 h 747397"/>
                <a:gd name="connsiteX11" fmla="*/ 350586 w 662029"/>
                <a:gd name="connsiteY11" fmla="*/ 285943 h 747397"/>
                <a:gd name="connsiteX12" fmla="*/ 377746 w 662029"/>
                <a:gd name="connsiteY12" fmla="*/ 5286 h 747397"/>
                <a:gd name="connsiteX0" fmla="*/ 377746 w 644841"/>
                <a:gd name="connsiteY0" fmla="*/ 5286 h 747397"/>
                <a:gd name="connsiteX1" fmla="*/ 558816 w 644841"/>
                <a:gd name="connsiteY1" fmla="*/ 113927 h 747397"/>
                <a:gd name="connsiteX2" fmla="*/ 629076 w 644841"/>
                <a:gd name="connsiteY2" fmla="*/ 257159 h 747397"/>
                <a:gd name="connsiteX3" fmla="*/ 638443 w 644841"/>
                <a:gd name="connsiteY3" fmla="*/ 440833 h 747397"/>
                <a:gd name="connsiteX4" fmla="*/ 549762 w 644841"/>
                <a:gd name="connsiteY4" fmla="*/ 620921 h 747397"/>
                <a:gd name="connsiteX5" fmla="*/ 232616 w 644841"/>
                <a:gd name="connsiteY5" fmla="*/ 746770 h 747397"/>
                <a:gd name="connsiteX6" fmla="*/ 33521 w 644841"/>
                <a:gd name="connsiteY6" fmla="*/ 659016 h 747397"/>
                <a:gd name="connsiteX7" fmla="*/ 12258 w 644841"/>
                <a:gd name="connsiteY7" fmla="*/ 438530 h 747397"/>
                <a:gd name="connsiteX8" fmla="*/ 160463 w 644841"/>
                <a:gd name="connsiteY8" fmla="*/ 204462 h 747397"/>
                <a:gd name="connsiteX9" fmla="*/ 214784 w 644841"/>
                <a:gd name="connsiteY9" fmla="*/ 258783 h 747397"/>
                <a:gd name="connsiteX10" fmla="*/ 232891 w 644841"/>
                <a:gd name="connsiteY10" fmla="*/ 467012 h 747397"/>
                <a:gd name="connsiteX11" fmla="*/ 350586 w 644841"/>
                <a:gd name="connsiteY11" fmla="*/ 285943 h 747397"/>
                <a:gd name="connsiteX12" fmla="*/ 377746 w 644841"/>
                <a:gd name="connsiteY12" fmla="*/ 5286 h 747397"/>
                <a:gd name="connsiteX0" fmla="*/ 377746 w 648575"/>
                <a:gd name="connsiteY0" fmla="*/ 5286 h 747397"/>
                <a:gd name="connsiteX1" fmla="*/ 558816 w 648575"/>
                <a:gd name="connsiteY1" fmla="*/ 113927 h 747397"/>
                <a:gd name="connsiteX2" fmla="*/ 629076 w 648575"/>
                <a:gd name="connsiteY2" fmla="*/ 257159 h 747397"/>
                <a:gd name="connsiteX3" fmla="*/ 638443 w 648575"/>
                <a:gd name="connsiteY3" fmla="*/ 440833 h 747397"/>
                <a:gd name="connsiteX4" fmla="*/ 549762 w 648575"/>
                <a:gd name="connsiteY4" fmla="*/ 620921 h 747397"/>
                <a:gd name="connsiteX5" fmla="*/ 232616 w 648575"/>
                <a:gd name="connsiteY5" fmla="*/ 746770 h 747397"/>
                <a:gd name="connsiteX6" fmla="*/ 33521 w 648575"/>
                <a:gd name="connsiteY6" fmla="*/ 659016 h 747397"/>
                <a:gd name="connsiteX7" fmla="*/ 12258 w 648575"/>
                <a:gd name="connsiteY7" fmla="*/ 438530 h 747397"/>
                <a:gd name="connsiteX8" fmla="*/ 160463 w 648575"/>
                <a:gd name="connsiteY8" fmla="*/ 204462 h 747397"/>
                <a:gd name="connsiteX9" fmla="*/ 214784 w 648575"/>
                <a:gd name="connsiteY9" fmla="*/ 258783 h 747397"/>
                <a:gd name="connsiteX10" fmla="*/ 232891 w 648575"/>
                <a:gd name="connsiteY10" fmla="*/ 467012 h 747397"/>
                <a:gd name="connsiteX11" fmla="*/ 350586 w 648575"/>
                <a:gd name="connsiteY11" fmla="*/ 285943 h 747397"/>
                <a:gd name="connsiteX12" fmla="*/ 377746 w 648575"/>
                <a:gd name="connsiteY12" fmla="*/ 5286 h 747397"/>
                <a:gd name="connsiteX0" fmla="*/ 377746 w 648316"/>
                <a:gd name="connsiteY0" fmla="*/ 5286 h 746789"/>
                <a:gd name="connsiteX1" fmla="*/ 558816 w 648316"/>
                <a:gd name="connsiteY1" fmla="*/ 113927 h 746789"/>
                <a:gd name="connsiteX2" fmla="*/ 629076 w 648316"/>
                <a:gd name="connsiteY2" fmla="*/ 257159 h 746789"/>
                <a:gd name="connsiteX3" fmla="*/ 638443 w 648316"/>
                <a:gd name="connsiteY3" fmla="*/ 440833 h 746789"/>
                <a:gd name="connsiteX4" fmla="*/ 502834 w 648316"/>
                <a:gd name="connsiteY4" fmla="*/ 653041 h 746789"/>
                <a:gd name="connsiteX5" fmla="*/ 232616 w 648316"/>
                <a:gd name="connsiteY5" fmla="*/ 746770 h 746789"/>
                <a:gd name="connsiteX6" fmla="*/ 33521 w 648316"/>
                <a:gd name="connsiteY6" fmla="*/ 659016 h 746789"/>
                <a:gd name="connsiteX7" fmla="*/ 12258 w 648316"/>
                <a:gd name="connsiteY7" fmla="*/ 438530 h 746789"/>
                <a:gd name="connsiteX8" fmla="*/ 160463 w 648316"/>
                <a:gd name="connsiteY8" fmla="*/ 204462 h 746789"/>
                <a:gd name="connsiteX9" fmla="*/ 214784 w 648316"/>
                <a:gd name="connsiteY9" fmla="*/ 258783 h 746789"/>
                <a:gd name="connsiteX10" fmla="*/ 232891 w 648316"/>
                <a:gd name="connsiteY10" fmla="*/ 467012 h 746789"/>
                <a:gd name="connsiteX11" fmla="*/ 350586 w 648316"/>
                <a:gd name="connsiteY11" fmla="*/ 285943 h 746789"/>
                <a:gd name="connsiteX12" fmla="*/ 377746 w 648316"/>
                <a:gd name="connsiteY12" fmla="*/ 5286 h 74678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648316" h="746789">
                  <a:moveTo>
                    <a:pt x="377746" y="5286"/>
                  </a:moveTo>
                  <a:cubicBezTo>
                    <a:pt x="412451" y="-23383"/>
                    <a:pt x="516928" y="71948"/>
                    <a:pt x="558816" y="113927"/>
                  </a:cubicBezTo>
                  <a:cubicBezTo>
                    <a:pt x="600704" y="155906"/>
                    <a:pt x="615805" y="202675"/>
                    <a:pt x="629076" y="257159"/>
                  </a:cubicBezTo>
                  <a:cubicBezTo>
                    <a:pt x="642347" y="311643"/>
                    <a:pt x="659483" y="374853"/>
                    <a:pt x="638443" y="440833"/>
                  </a:cubicBezTo>
                  <a:cubicBezTo>
                    <a:pt x="617403" y="506813"/>
                    <a:pt x="570472" y="602052"/>
                    <a:pt x="502834" y="653041"/>
                  </a:cubicBezTo>
                  <a:cubicBezTo>
                    <a:pt x="435196" y="704030"/>
                    <a:pt x="310835" y="745774"/>
                    <a:pt x="232616" y="746770"/>
                  </a:cubicBezTo>
                  <a:cubicBezTo>
                    <a:pt x="154397" y="747766"/>
                    <a:pt x="70247" y="710389"/>
                    <a:pt x="33521" y="659016"/>
                  </a:cubicBezTo>
                  <a:cubicBezTo>
                    <a:pt x="-3205" y="607643"/>
                    <a:pt x="-8899" y="514289"/>
                    <a:pt x="12258" y="438530"/>
                  </a:cubicBezTo>
                  <a:cubicBezTo>
                    <a:pt x="33415" y="362771"/>
                    <a:pt x="126709" y="234420"/>
                    <a:pt x="160463" y="204462"/>
                  </a:cubicBezTo>
                  <a:cubicBezTo>
                    <a:pt x="194217" y="174504"/>
                    <a:pt x="202713" y="215025"/>
                    <a:pt x="214784" y="258783"/>
                  </a:cubicBezTo>
                  <a:cubicBezTo>
                    <a:pt x="226855" y="302541"/>
                    <a:pt x="210257" y="462485"/>
                    <a:pt x="232891" y="467012"/>
                  </a:cubicBezTo>
                  <a:cubicBezTo>
                    <a:pt x="255525" y="471539"/>
                    <a:pt x="326443" y="362897"/>
                    <a:pt x="350586" y="285943"/>
                  </a:cubicBezTo>
                  <a:cubicBezTo>
                    <a:pt x="374728" y="208989"/>
                    <a:pt x="343041" y="33955"/>
                    <a:pt x="377746" y="5286"/>
                  </a:cubicBezTo>
                  <a:close/>
                </a:path>
              </a:pathLst>
            </a:custGeom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8" name="フリーフォーム 17">
              <a:extLst>
                <a:ext uri="{FF2B5EF4-FFF2-40B4-BE49-F238E27FC236}">
                  <a16:creationId xmlns:a16="http://schemas.microsoft.com/office/drawing/2014/main" id="{13622E77-CEAA-A432-004F-DA78A5A6D774}"/>
                </a:ext>
              </a:extLst>
            </p:cNvPr>
            <p:cNvSpPr/>
            <p:nvPr/>
          </p:nvSpPr>
          <p:spPr>
            <a:xfrm rot="172039">
              <a:off x="4570698" y="3844996"/>
              <a:ext cx="697457" cy="828616"/>
            </a:xfrm>
            <a:custGeom>
              <a:avLst/>
              <a:gdLst>
                <a:gd name="connsiteX0" fmla="*/ 14779 w 684780"/>
                <a:gd name="connsiteY0" fmla="*/ 157597 h 826087"/>
                <a:gd name="connsiteX1" fmla="*/ 141527 w 684780"/>
                <a:gd name="connsiteY1" fmla="*/ 12741 h 826087"/>
                <a:gd name="connsiteX2" fmla="*/ 277329 w 684780"/>
                <a:gd name="connsiteY2" fmla="*/ 12741 h 826087"/>
                <a:gd name="connsiteX3" fmla="*/ 376917 w 684780"/>
                <a:gd name="connsiteY3" fmla="*/ 12741 h 826087"/>
                <a:gd name="connsiteX4" fmla="*/ 612307 w 684780"/>
                <a:gd name="connsiteY4" fmla="*/ 184757 h 826087"/>
                <a:gd name="connsiteX5" fmla="*/ 684735 w 684780"/>
                <a:gd name="connsiteY5" fmla="*/ 411094 h 826087"/>
                <a:gd name="connsiteX6" fmla="*/ 621361 w 684780"/>
                <a:gd name="connsiteY6" fmla="*/ 709858 h 826087"/>
                <a:gd name="connsiteX7" fmla="*/ 512719 w 684780"/>
                <a:gd name="connsiteY7" fmla="*/ 809446 h 826087"/>
                <a:gd name="connsiteX8" fmla="*/ 458398 w 684780"/>
                <a:gd name="connsiteY8" fmla="*/ 809446 h 826087"/>
                <a:gd name="connsiteX9" fmla="*/ 313543 w 684780"/>
                <a:gd name="connsiteY9" fmla="*/ 646484 h 826087"/>
                <a:gd name="connsiteX10" fmla="*/ 168688 w 684780"/>
                <a:gd name="connsiteY10" fmla="*/ 510682 h 826087"/>
                <a:gd name="connsiteX11" fmla="*/ 23832 w 684780"/>
                <a:gd name="connsiteY11" fmla="*/ 320559 h 826087"/>
                <a:gd name="connsiteX12" fmla="*/ 14779 w 684780"/>
                <a:gd name="connsiteY12" fmla="*/ 157597 h 826087"/>
                <a:gd name="connsiteX0" fmla="*/ 45002 w 715003"/>
                <a:gd name="connsiteY0" fmla="*/ 157597 h 826087"/>
                <a:gd name="connsiteX1" fmla="*/ 171750 w 715003"/>
                <a:gd name="connsiteY1" fmla="*/ 12741 h 826087"/>
                <a:gd name="connsiteX2" fmla="*/ 307552 w 715003"/>
                <a:gd name="connsiteY2" fmla="*/ 12741 h 826087"/>
                <a:gd name="connsiteX3" fmla="*/ 407140 w 715003"/>
                <a:gd name="connsiteY3" fmla="*/ 12741 h 826087"/>
                <a:gd name="connsiteX4" fmla="*/ 642530 w 715003"/>
                <a:gd name="connsiteY4" fmla="*/ 184757 h 826087"/>
                <a:gd name="connsiteX5" fmla="*/ 714958 w 715003"/>
                <a:gd name="connsiteY5" fmla="*/ 411094 h 826087"/>
                <a:gd name="connsiteX6" fmla="*/ 651584 w 715003"/>
                <a:gd name="connsiteY6" fmla="*/ 709858 h 826087"/>
                <a:gd name="connsiteX7" fmla="*/ 542942 w 715003"/>
                <a:gd name="connsiteY7" fmla="*/ 809446 h 826087"/>
                <a:gd name="connsiteX8" fmla="*/ 488621 w 715003"/>
                <a:gd name="connsiteY8" fmla="*/ 809446 h 826087"/>
                <a:gd name="connsiteX9" fmla="*/ 343766 w 715003"/>
                <a:gd name="connsiteY9" fmla="*/ 646484 h 826087"/>
                <a:gd name="connsiteX10" fmla="*/ 198911 w 715003"/>
                <a:gd name="connsiteY10" fmla="*/ 510682 h 826087"/>
                <a:gd name="connsiteX11" fmla="*/ 12011 w 715003"/>
                <a:gd name="connsiteY11" fmla="*/ 327700 h 826087"/>
                <a:gd name="connsiteX12" fmla="*/ 45002 w 715003"/>
                <a:gd name="connsiteY12" fmla="*/ 157597 h 826087"/>
                <a:gd name="connsiteX0" fmla="*/ 31399 w 701400"/>
                <a:gd name="connsiteY0" fmla="*/ 157597 h 826087"/>
                <a:gd name="connsiteX1" fmla="*/ 158147 w 701400"/>
                <a:gd name="connsiteY1" fmla="*/ 12741 h 826087"/>
                <a:gd name="connsiteX2" fmla="*/ 293949 w 701400"/>
                <a:gd name="connsiteY2" fmla="*/ 12741 h 826087"/>
                <a:gd name="connsiteX3" fmla="*/ 393537 w 701400"/>
                <a:gd name="connsiteY3" fmla="*/ 12741 h 826087"/>
                <a:gd name="connsiteX4" fmla="*/ 628927 w 701400"/>
                <a:gd name="connsiteY4" fmla="*/ 184757 h 826087"/>
                <a:gd name="connsiteX5" fmla="*/ 701355 w 701400"/>
                <a:gd name="connsiteY5" fmla="*/ 411094 h 826087"/>
                <a:gd name="connsiteX6" fmla="*/ 637981 w 701400"/>
                <a:gd name="connsiteY6" fmla="*/ 709858 h 826087"/>
                <a:gd name="connsiteX7" fmla="*/ 529339 w 701400"/>
                <a:gd name="connsiteY7" fmla="*/ 809446 h 826087"/>
                <a:gd name="connsiteX8" fmla="*/ 475018 w 701400"/>
                <a:gd name="connsiteY8" fmla="*/ 809446 h 826087"/>
                <a:gd name="connsiteX9" fmla="*/ 330163 w 701400"/>
                <a:gd name="connsiteY9" fmla="*/ 646484 h 826087"/>
                <a:gd name="connsiteX10" fmla="*/ 185308 w 701400"/>
                <a:gd name="connsiteY10" fmla="*/ 510682 h 826087"/>
                <a:gd name="connsiteX11" fmla="*/ 15186 w 701400"/>
                <a:gd name="connsiteY11" fmla="*/ 314667 h 826087"/>
                <a:gd name="connsiteX12" fmla="*/ 31399 w 701400"/>
                <a:gd name="connsiteY12" fmla="*/ 157597 h 826087"/>
                <a:gd name="connsiteX0" fmla="*/ 31399 w 701400"/>
                <a:gd name="connsiteY0" fmla="*/ 157597 h 823572"/>
                <a:gd name="connsiteX1" fmla="*/ 158147 w 701400"/>
                <a:gd name="connsiteY1" fmla="*/ 12741 h 823572"/>
                <a:gd name="connsiteX2" fmla="*/ 293949 w 701400"/>
                <a:gd name="connsiteY2" fmla="*/ 12741 h 823572"/>
                <a:gd name="connsiteX3" fmla="*/ 393537 w 701400"/>
                <a:gd name="connsiteY3" fmla="*/ 12741 h 823572"/>
                <a:gd name="connsiteX4" fmla="*/ 628927 w 701400"/>
                <a:gd name="connsiteY4" fmla="*/ 184757 h 823572"/>
                <a:gd name="connsiteX5" fmla="*/ 701355 w 701400"/>
                <a:gd name="connsiteY5" fmla="*/ 411094 h 823572"/>
                <a:gd name="connsiteX6" fmla="*/ 637981 w 701400"/>
                <a:gd name="connsiteY6" fmla="*/ 709858 h 823572"/>
                <a:gd name="connsiteX7" fmla="*/ 529339 w 701400"/>
                <a:gd name="connsiteY7" fmla="*/ 809446 h 823572"/>
                <a:gd name="connsiteX8" fmla="*/ 475018 w 701400"/>
                <a:gd name="connsiteY8" fmla="*/ 809446 h 823572"/>
                <a:gd name="connsiteX9" fmla="*/ 314544 w 701400"/>
                <a:gd name="connsiteY9" fmla="*/ 683762 h 823572"/>
                <a:gd name="connsiteX10" fmla="*/ 185308 w 701400"/>
                <a:gd name="connsiteY10" fmla="*/ 510682 h 823572"/>
                <a:gd name="connsiteX11" fmla="*/ 15186 w 701400"/>
                <a:gd name="connsiteY11" fmla="*/ 314667 h 823572"/>
                <a:gd name="connsiteX12" fmla="*/ 31399 w 701400"/>
                <a:gd name="connsiteY12" fmla="*/ 157597 h 823572"/>
                <a:gd name="connsiteX0" fmla="*/ 27456 w 697457"/>
                <a:gd name="connsiteY0" fmla="*/ 157597 h 823572"/>
                <a:gd name="connsiteX1" fmla="*/ 154204 w 697457"/>
                <a:gd name="connsiteY1" fmla="*/ 12741 h 823572"/>
                <a:gd name="connsiteX2" fmla="*/ 290006 w 697457"/>
                <a:gd name="connsiteY2" fmla="*/ 12741 h 823572"/>
                <a:gd name="connsiteX3" fmla="*/ 389594 w 697457"/>
                <a:gd name="connsiteY3" fmla="*/ 12741 h 823572"/>
                <a:gd name="connsiteX4" fmla="*/ 624984 w 697457"/>
                <a:gd name="connsiteY4" fmla="*/ 184757 h 823572"/>
                <a:gd name="connsiteX5" fmla="*/ 697412 w 697457"/>
                <a:gd name="connsiteY5" fmla="*/ 411094 h 823572"/>
                <a:gd name="connsiteX6" fmla="*/ 634038 w 697457"/>
                <a:gd name="connsiteY6" fmla="*/ 709858 h 823572"/>
                <a:gd name="connsiteX7" fmla="*/ 525396 w 697457"/>
                <a:gd name="connsiteY7" fmla="*/ 809446 h 823572"/>
                <a:gd name="connsiteX8" fmla="*/ 471075 w 697457"/>
                <a:gd name="connsiteY8" fmla="*/ 809446 h 823572"/>
                <a:gd name="connsiteX9" fmla="*/ 310601 w 697457"/>
                <a:gd name="connsiteY9" fmla="*/ 683762 h 823572"/>
                <a:gd name="connsiteX10" fmla="*/ 164299 w 697457"/>
                <a:gd name="connsiteY10" fmla="*/ 517655 h 823572"/>
                <a:gd name="connsiteX11" fmla="*/ 11243 w 697457"/>
                <a:gd name="connsiteY11" fmla="*/ 314667 h 823572"/>
                <a:gd name="connsiteX12" fmla="*/ 27456 w 697457"/>
                <a:gd name="connsiteY12" fmla="*/ 157597 h 823572"/>
                <a:gd name="connsiteX0" fmla="*/ 27456 w 697457"/>
                <a:gd name="connsiteY0" fmla="*/ 161818 h 827793"/>
                <a:gd name="connsiteX1" fmla="*/ 154204 w 697457"/>
                <a:gd name="connsiteY1" fmla="*/ 16962 h 827793"/>
                <a:gd name="connsiteX2" fmla="*/ 289498 w 697457"/>
                <a:gd name="connsiteY2" fmla="*/ 6339 h 827793"/>
                <a:gd name="connsiteX3" fmla="*/ 389594 w 697457"/>
                <a:gd name="connsiteY3" fmla="*/ 16962 h 827793"/>
                <a:gd name="connsiteX4" fmla="*/ 624984 w 697457"/>
                <a:gd name="connsiteY4" fmla="*/ 188978 h 827793"/>
                <a:gd name="connsiteX5" fmla="*/ 697412 w 697457"/>
                <a:gd name="connsiteY5" fmla="*/ 415315 h 827793"/>
                <a:gd name="connsiteX6" fmla="*/ 634038 w 697457"/>
                <a:gd name="connsiteY6" fmla="*/ 714079 h 827793"/>
                <a:gd name="connsiteX7" fmla="*/ 525396 w 697457"/>
                <a:gd name="connsiteY7" fmla="*/ 813667 h 827793"/>
                <a:gd name="connsiteX8" fmla="*/ 471075 w 697457"/>
                <a:gd name="connsiteY8" fmla="*/ 813667 h 827793"/>
                <a:gd name="connsiteX9" fmla="*/ 310601 w 697457"/>
                <a:gd name="connsiteY9" fmla="*/ 687983 h 827793"/>
                <a:gd name="connsiteX10" fmla="*/ 164299 w 697457"/>
                <a:gd name="connsiteY10" fmla="*/ 521876 h 827793"/>
                <a:gd name="connsiteX11" fmla="*/ 11243 w 697457"/>
                <a:gd name="connsiteY11" fmla="*/ 318888 h 827793"/>
                <a:gd name="connsiteX12" fmla="*/ 27456 w 697457"/>
                <a:gd name="connsiteY12" fmla="*/ 161818 h 827793"/>
                <a:gd name="connsiteX0" fmla="*/ 27456 w 697457"/>
                <a:gd name="connsiteY0" fmla="*/ 162641 h 828616"/>
                <a:gd name="connsiteX1" fmla="*/ 154204 w 697457"/>
                <a:gd name="connsiteY1" fmla="*/ 17785 h 828616"/>
                <a:gd name="connsiteX2" fmla="*/ 289498 w 697457"/>
                <a:gd name="connsiteY2" fmla="*/ 7162 h 828616"/>
                <a:gd name="connsiteX3" fmla="*/ 467925 w 697457"/>
                <a:gd name="connsiteY3" fmla="*/ 61593 h 828616"/>
                <a:gd name="connsiteX4" fmla="*/ 624984 w 697457"/>
                <a:gd name="connsiteY4" fmla="*/ 189801 h 828616"/>
                <a:gd name="connsiteX5" fmla="*/ 697412 w 697457"/>
                <a:gd name="connsiteY5" fmla="*/ 416138 h 828616"/>
                <a:gd name="connsiteX6" fmla="*/ 634038 w 697457"/>
                <a:gd name="connsiteY6" fmla="*/ 714902 h 828616"/>
                <a:gd name="connsiteX7" fmla="*/ 525396 w 697457"/>
                <a:gd name="connsiteY7" fmla="*/ 814490 h 828616"/>
                <a:gd name="connsiteX8" fmla="*/ 471075 w 697457"/>
                <a:gd name="connsiteY8" fmla="*/ 814490 h 828616"/>
                <a:gd name="connsiteX9" fmla="*/ 310601 w 697457"/>
                <a:gd name="connsiteY9" fmla="*/ 688806 h 828616"/>
                <a:gd name="connsiteX10" fmla="*/ 164299 w 697457"/>
                <a:gd name="connsiteY10" fmla="*/ 522699 h 828616"/>
                <a:gd name="connsiteX11" fmla="*/ 11243 w 697457"/>
                <a:gd name="connsiteY11" fmla="*/ 319711 h 828616"/>
                <a:gd name="connsiteX12" fmla="*/ 27456 w 697457"/>
                <a:gd name="connsiteY12" fmla="*/ 162641 h 82861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697457" h="828616">
                  <a:moveTo>
                    <a:pt x="27456" y="162641"/>
                  </a:moveTo>
                  <a:cubicBezTo>
                    <a:pt x="51283" y="112320"/>
                    <a:pt x="110530" y="43698"/>
                    <a:pt x="154204" y="17785"/>
                  </a:cubicBezTo>
                  <a:cubicBezTo>
                    <a:pt x="197878" y="-8128"/>
                    <a:pt x="237211" y="-139"/>
                    <a:pt x="289498" y="7162"/>
                  </a:cubicBezTo>
                  <a:cubicBezTo>
                    <a:pt x="341785" y="14463"/>
                    <a:pt x="412011" y="31153"/>
                    <a:pt x="467925" y="61593"/>
                  </a:cubicBezTo>
                  <a:cubicBezTo>
                    <a:pt x="523839" y="92033"/>
                    <a:pt x="586736" y="130710"/>
                    <a:pt x="624984" y="189801"/>
                  </a:cubicBezTo>
                  <a:cubicBezTo>
                    <a:pt x="663232" y="248892"/>
                    <a:pt x="695903" y="328621"/>
                    <a:pt x="697412" y="416138"/>
                  </a:cubicBezTo>
                  <a:cubicBezTo>
                    <a:pt x="698921" y="503655"/>
                    <a:pt x="662707" y="648510"/>
                    <a:pt x="634038" y="714902"/>
                  </a:cubicBezTo>
                  <a:cubicBezTo>
                    <a:pt x="605369" y="781294"/>
                    <a:pt x="552557" y="797892"/>
                    <a:pt x="525396" y="814490"/>
                  </a:cubicBezTo>
                  <a:cubicBezTo>
                    <a:pt x="498236" y="831088"/>
                    <a:pt x="506874" y="835437"/>
                    <a:pt x="471075" y="814490"/>
                  </a:cubicBezTo>
                  <a:cubicBezTo>
                    <a:pt x="435276" y="793543"/>
                    <a:pt x="361730" y="737438"/>
                    <a:pt x="310601" y="688806"/>
                  </a:cubicBezTo>
                  <a:cubicBezTo>
                    <a:pt x="259472" y="640174"/>
                    <a:pt x="212584" y="577020"/>
                    <a:pt x="164299" y="522699"/>
                  </a:cubicBezTo>
                  <a:cubicBezTo>
                    <a:pt x="116014" y="468378"/>
                    <a:pt x="34050" y="379721"/>
                    <a:pt x="11243" y="319711"/>
                  </a:cubicBezTo>
                  <a:cubicBezTo>
                    <a:pt x="-11564" y="259701"/>
                    <a:pt x="3629" y="212962"/>
                    <a:pt x="27456" y="162641"/>
                  </a:cubicBezTo>
                  <a:close/>
                </a:path>
              </a:pathLst>
            </a:custGeom>
            <a:solidFill>
              <a:srgbClr val="92D050"/>
            </a:solidFill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19" name="フリーフォーム 18">
              <a:extLst>
                <a:ext uri="{FF2B5EF4-FFF2-40B4-BE49-F238E27FC236}">
                  <a16:creationId xmlns:a16="http://schemas.microsoft.com/office/drawing/2014/main" id="{D5E5A5A8-86A7-0E0D-8E39-F085F39BFBA0}"/>
                </a:ext>
              </a:extLst>
            </p:cNvPr>
            <p:cNvSpPr/>
            <p:nvPr/>
          </p:nvSpPr>
          <p:spPr>
            <a:xfrm>
              <a:off x="5348314" y="2321616"/>
              <a:ext cx="499644" cy="606340"/>
            </a:xfrm>
            <a:custGeom>
              <a:avLst/>
              <a:gdLst>
                <a:gd name="connsiteX0" fmla="*/ 64462 w 499644"/>
                <a:gd name="connsiteY0" fmla="*/ 455075 h 606340"/>
                <a:gd name="connsiteX1" fmla="*/ 1087 w 499644"/>
                <a:gd name="connsiteY1" fmla="*/ 210632 h 606340"/>
                <a:gd name="connsiteX2" fmla="*/ 118782 w 499644"/>
                <a:gd name="connsiteY2" fmla="*/ 20509 h 606340"/>
                <a:gd name="connsiteX3" fmla="*/ 236477 w 499644"/>
                <a:gd name="connsiteY3" fmla="*/ 20509 h 606340"/>
                <a:gd name="connsiteX4" fmla="*/ 399440 w 499644"/>
                <a:gd name="connsiteY4" fmla="*/ 156311 h 606340"/>
                <a:gd name="connsiteX5" fmla="*/ 499028 w 499644"/>
                <a:gd name="connsiteY5" fmla="*/ 400755 h 606340"/>
                <a:gd name="connsiteX6" fmla="*/ 354172 w 499644"/>
                <a:gd name="connsiteY6" fmla="*/ 599931 h 606340"/>
                <a:gd name="connsiteX7" fmla="*/ 136889 w 499644"/>
                <a:gd name="connsiteY7" fmla="*/ 545610 h 606340"/>
                <a:gd name="connsiteX8" fmla="*/ 64462 w 499644"/>
                <a:gd name="connsiteY8" fmla="*/ 455075 h 6063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499644" h="606340">
                  <a:moveTo>
                    <a:pt x="64462" y="455075"/>
                  </a:moveTo>
                  <a:cubicBezTo>
                    <a:pt x="41828" y="399245"/>
                    <a:pt x="-7966" y="283059"/>
                    <a:pt x="1087" y="210632"/>
                  </a:cubicBezTo>
                  <a:cubicBezTo>
                    <a:pt x="10140" y="138205"/>
                    <a:pt x="79550" y="52196"/>
                    <a:pt x="118782" y="20509"/>
                  </a:cubicBezTo>
                  <a:cubicBezTo>
                    <a:pt x="158014" y="-11178"/>
                    <a:pt x="189701" y="-2125"/>
                    <a:pt x="236477" y="20509"/>
                  </a:cubicBezTo>
                  <a:cubicBezTo>
                    <a:pt x="283253" y="43143"/>
                    <a:pt x="355682" y="92937"/>
                    <a:pt x="399440" y="156311"/>
                  </a:cubicBezTo>
                  <a:cubicBezTo>
                    <a:pt x="443199" y="219685"/>
                    <a:pt x="506573" y="326818"/>
                    <a:pt x="499028" y="400755"/>
                  </a:cubicBezTo>
                  <a:cubicBezTo>
                    <a:pt x="491483" y="474692"/>
                    <a:pt x="414528" y="575789"/>
                    <a:pt x="354172" y="599931"/>
                  </a:cubicBezTo>
                  <a:cubicBezTo>
                    <a:pt x="293816" y="624073"/>
                    <a:pt x="180647" y="574279"/>
                    <a:pt x="136889" y="545610"/>
                  </a:cubicBezTo>
                  <a:cubicBezTo>
                    <a:pt x="93131" y="516941"/>
                    <a:pt x="87096" y="510905"/>
                    <a:pt x="64462" y="455075"/>
                  </a:cubicBezTo>
                  <a:close/>
                </a:path>
              </a:pathLst>
            </a:custGeom>
            <a:solidFill>
              <a:srgbClr val="C889E9"/>
            </a:solidFill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A1752F6F-735C-276D-0CA2-352DE803E32C}"/>
                </a:ext>
              </a:extLst>
            </p:cNvPr>
            <p:cNvSpPr txBox="1"/>
            <p:nvPr/>
          </p:nvSpPr>
          <p:spPr>
            <a:xfrm>
              <a:off x="6976794" y="1403284"/>
              <a:ext cx="2584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/>
                <a:t>I</a:t>
              </a:r>
              <a:endParaRPr kumimoji="1" lang="ja-JP" altLang="en-US" b="1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77D63627-2298-35AA-ADCE-63A7F8F6BA38}"/>
                </a:ext>
              </a:extLst>
            </p:cNvPr>
            <p:cNvSpPr txBox="1"/>
            <p:nvPr/>
          </p:nvSpPr>
          <p:spPr>
            <a:xfrm>
              <a:off x="7115174" y="3649090"/>
              <a:ext cx="33214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/>
                <a:t>II</a:t>
              </a:r>
              <a:endParaRPr kumimoji="1" lang="ja-JP" altLang="en-US" b="1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DCA06B0B-0A24-0DF6-C23F-D1917574515D}"/>
                </a:ext>
              </a:extLst>
            </p:cNvPr>
            <p:cNvSpPr txBox="1"/>
            <p:nvPr/>
          </p:nvSpPr>
          <p:spPr>
            <a:xfrm>
              <a:off x="4754404" y="4051874"/>
              <a:ext cx="40588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ja-JP" b="1" dirty="0"/>
                <a:t>III</a:t>
              </a:r>
              <a:endParaRPr kumimoji="1" lang="ja-JP" altLang="en-US" b="1"/>
            </a:p>
          </p:txBody>
        </p:sp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B19177F5-E85E-66B8-DAC9-524303F4CEC6}"/>
                </a:ext>
              </a:extLst>
            </p:cNvPr>
            <p:cNvSpPr txBox="1"/>
            <p:nvPr/>
          </p:nvSpPr>
          <p:spPr>
            <a:xfrm>
              <a:off x="5383241" y="2486199"/>
              <a:ext cx="482824" cy="369332"/>
            </a:xfrm>
            <a:prstGeom prst="rect">
              <a:avLst/>
            </a:prstGeom>
            <a:noFill/>
            <a:ln>
              <a:noFill/>
            </a:ln>
          </p:spPr>
          <p:txBody>
            <a:bodyPr wrap="none" rtlCol="0">
              <a:spAutoFit/>
            </a:bodyPr>
            <a:lstStyle/>
            <a:p>
              <a:r>
                <a:rPr lang="en-US" altLang="ja-JP" b="1" dirty="0"/>
                <a:t>IV </a:t>
              </a:r>
              <a:endParaRPr kumimoji="1" lang="ja-JP" altLang="en-US" b="1"/>
            </a:p>
          </p:txBody>
        </p:sp>
      </p:grp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762FFEDD-5A96-BE6F-F8E9-A0A46A56CADD}"/>
              </a:ext>
            </a:extLst>
          </p:cNvPr>
          <p:cNvSpPr txBox="1"/>
          <p:nvPr/>
        </p:nvSpPr>
        <p:spPr>
          <a:xfrm>
            <a:off x="438839" y="5280958"/>
            <a:ext cx="1131432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. 1 Contrast-enhancing lesions (</a:t>
            </a:r>
            <a:r>
              <a:rPr lang="en-US" altLang="ja-JP" sz="1800" kern="100" dirty="0" err="1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ELs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) of GBM were classified into four groups. Group Ⅰ: the CEL extends from the atrium SVZ to the pia. Group II: the CEL touches the SVZ but does not involve the cortex. Group III: the CEL invades the cortex and reaches the pia but does not touch the SVZ. Group IV: the CEL touches neither the cortex nor the SVZ.</a:t>
            </a:r>
            <a:endParaRPr lang="ja-JP" altLang="ja-JP" sz="1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31151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6</TotalTime>
  <Words>83</Words>
  <Application>Microsoft Macintosh PowerPoint</Application>
  <PresentationFormat>ワイド画面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游明朝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ｖ</dc:title>
  <dc:creator>gyomu</dc:creator>
  <cp:lastModifiedBy>那優大 比嘉</cp:lastModifiedBy>
  <cp:revision>10</cp:revision>
  <dcterms:created xsi:type="dcterms:W3CDTF">2022-05-15T02:49:54Z</dcterms:created>
  <dcterms:modified xsi:type="dcterms:W3CDTF">2023-08-08T12:39:43Z</dcterms:modified>
</cp:coreProperties>
</file>